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9"/>
  </p:notesMasterIdLst>
  <p:sldIdLst>
    <p:sldId id="275" r:id="rId2"/>
    <p:sldId id="341" r:id="rId3"/>
    <p:sldId id="342" r:id="rId4"/>
    <p:sldId id="343" r:id="rId5"/>
    <p:sldId id="344" r:id="rId6"/>
    <p:sldId id="345" r:id="rId7"/>
    <p:sldId id="346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3FEFF"/>
    <a:srgbClr val="FF7E79"/>
    <a:srgbClr val="02FF00"/>
    <a:srgbClr val="FFF2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60"/>
    <p:restoredTop sz="97654"/>
  </p:normalViewPr>
  <p:slideViewPr>
    <p:cSldViewPr snapToGrid="0">
      <p:cViewPr varScale="1">
        <p:scale>
          <a:sx n="92" d="100"/>
          <a:sy n="92" d="100"/>
        </p:scale>
        <p:origin x="37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ACF953-C57F-EB4A-A397-C2E5F56A31AE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D4FC50-55FD-4845-9ADA-7EE4F3BC54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6396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2D6AD8-626F-5444-AC48-3D4F405F4393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20429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2081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3822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4002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6508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5065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3799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6013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3809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4455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3790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1616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D05DA-305C-1746-B8FF-94967069F73F}" type="datetimeFigureOut">
              <a:rPr lang="en-US" smtClean="0"/>
              <a:t>2/23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016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55CF4055-E920-6DF8-9261-AFB82A1CFF2F}"/>
              </a:ext>
            </a:extLst>
          </p:cNvPr>
          <p:cNvCxnSpPr/>
          <p:nvPr/>
        </p:nvCxnSpPr>
        <p:spPr>
          <a:xfrm>
            <a:off x="2388971" y="2676018"/>
            <a:ext cx="0" cy="139700"/>
          </a:xfrm>
          <a:prstGeom prst="line">
            <a:avLst/>
          </a:prstGeom>
          <a:ln w="25400">
            <a:solidFill>
              <a:srgbClr val="00B05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6488395A-C1B2-946B-0F68-6E6DA8145867}"/>
              </a:ext>
            </a:extLst>
          </p:cNvPr>
          <p:cNvCxnSpPr/>
          <p:nvPr/>
        </p:nvCxnSpPr>
        <p:spPr>
          <a:xfrm>
            <a:off x="3149293" y="2676017"/>
            <a:ext cx="0" cy="139700"/>
          </a:xfrm>
          <a:prstGeom prst="line">
            <a:avLst/>
          </a:prstGeom>
          <a:ln w="25400">
            <a:solidFill>
              <a:srgbClr val="00B05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3" name="Rectangle 102">
            <a:extLst>
              <a:ext uri="{FF2B5EF4-FFF2-40B4-BE49-F238E27FC236}">
                <a16:creationId xmlns:a16="http://schemas.microsoft.com/office/drawing/2014/main" id="{A9F4F753-8F7E-B82C-59E9-6DCA32C3045C}"/>
              </a:ext>
            </a:extLst>
          </p:cNvPr>
          <p:cNvSpPr/>
          <p:nvPr/>
        </p:nvSpPr>
        <p:spPr>
          <a:xfrm>
            <a:off x="5106510" y="2803126"/>
            <a:ext cx="290654" cy="313215"/>
          </a:xfrm>
          <a:prstGeom prst="rect">
            <a:avLst/>
          </a:prstGeom>
          <a:solidFill>
            <a:srgbClr val="00B050">
              <a:alpha val="75834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047F2C44-0D50-0D03-E9D0-8E082F6ADAC2}"/>
              </a:ext>
            </a:extLst>
          </p:cNvPr>
          <p:cNvSpPr/>
          <p:nvPr/>
        </p:nvSpPr>
        <p:spPr>
          <a:xfrm>
            <a:off x="3714186" y="2809367"/>
            <a:ext cx="1393060" cy="306974"/>
          </a:xfrm>
          <a:prstGeom prst="rect">
            <a:avLst/>
          </a:prstGeom>
          <a:solidFill>
            <a:schemeClr val="bg1">
              <a:lumMod val="65000"/>
              <a:alpha val="75834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2940932C-A062-09B8-2C14-CF1468E57226}"/>
              </a:ext>
            </a:extLst>
          </p:cNvPr>
          <p:cNvSpPr/>
          <p:nvPr/>
        </p:nvSpPr>
        <p:spPr>
          <a:xfrm>
            <a:off x="3396510" y="2803126"/>
            <a:ext cx="320296" cy="306973"/>
          </a:xfrm>
          <a:prstGeom prst="rect">
            <a:avLst/>
          </a:prstGeom>
          <a:solidFill>
            <a:srgbClr val="FFC000">
              <a:alpha val="41824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1E4A25E6-8895-B7E7-C644-87BE84029C3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2181" t="22761" r="26827" b="31494"/>
          <a:stretch>
            <a:fillRect/>
          </a:stretch>
        </p:blipFill>
        <p:spPr>
          <a:xfrm>
            <a:off x="1089691" y="6920178"/>
            <a:ext cx="946233" cy="1300454"/>
          </a:xfrm>
          <a:prstGeom prst="rect">
            <a:avLst/>
          </a:prstGeom>
        </p:spPr>
      </p:pic>
      <p:grpSp>
        <p:nvGrpSpPr>
          <p:cNvPr id="131" name="Group 130">
            <a:extLst>
              <a:ext uri="{FF2B5EF4-FFF2-40B4-BE49-F238E27FC236}">
                <a16:creationId xmlns:a16="http://schemas.microsoft.com/office/drawing/2014/main" id="{858D96DA-44BD-7EA1-7C88-D9F80BA5E130}"/>
              </a:ext>
            </a:extLst>
          </p:cNvPr>
          <p:cNvGrpSpPr/>
          <p:nvPr/>
        </p:nvGrpSpPr>
        <p:grpSpPr>
          <a:xfrm>
            <a:off x="404749" y="5592285"/>
            <a:ext cx="2382725" cy="3114974"/>
            <a:chOff x="296583" y="5902628"/>
            <a:chExt cx="2382725" cy="3114974"/>
          </a:xfrm>
        </p:grpSpPr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8B962D17-1523-F392-3ED1-9E4CEE27B22F}"/>
                </a:ext>
              </a:extLst>
            </p:cNvPr>
            <p:cNvSpPr txBox="1"/>
            <p:nvPr/>
          </p:nvSpPr>
          <p:spPr>
            <a:xfrm>
              <a:off x="397716" y="8524744"/>
              <a:ext cx="10943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reatment:        </a:t>
              </a:r>
            </a:p>
          </p:txBody>
        </p:sp>
        <p:pic>
          <p:nvPicPr>
            <p:cNvPr id="174" name="Picture 173" descr="A close-up of a microscope&#10;&#10;AI-generated content may be incorrect.">
              <a:extLst>
                <a:ext uri="{FF2B5EF4-FFF2-40B4-BE49-F238E27FC236}">
                  <a16:creationId xmlns:a16="http://schemas.microsoft.com/office/drawing/2014/main" id="{7035713A-7532-4CE9-4DE8-AC1B4913963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01074" y="6097169"/>
              <a:ext cx="1083734" cy="914400"/>
            </a:xfrm>
            <a:prstGeom prst="rect">
              <a:avLst/>
            </a:prstGeom>
          </p:spPr>
        </p:pic>
        <p:pic>
          <p:nvPicPr>
            <p:cNvPr id="179" name="Picture 178" descr="A close-up of a microscope&#10;&#10;AI-generated content may be incorrect.">
              <a:extLst>
                <a:ext uri="{FF2B5EF4-FFF2-40B4-BE49-F238E27FC236}">
                  <a16:creationId xmlns:a16="http://schemas.microsoft.com/office/drawing/2014/main" id="{27BDF4A4-D8D9-3DEC-7326-B1DC463EB04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95574" y="6094922"/>
              <a:ext cx="1083734" cy="914400"/>
            </a:xfrm>
            <a:prstGeom prst="rect">
              <a:avLst/>
            </a:prstGeom>
          </p:spPr>
        </p:pic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B7017FC6-5EED-1759-4B84-EE8B34C3F437}"/>
                </a:ext>
              </a:extLst>
            </p:cNvPr>
            <p:cNvSpPr txBox="1"/>
            <p:nvPr/>
          </p:nvSpPr>
          <p:spPr>
            <a:xfrm>
              <a:off x="1057418" y="8524744"/>
              <a:ext cx="5117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EDAFBBA0-80C5-7BF1-2E1B-10EBB8AF6B97}"/>
                </a:ext>
              </a:extLst>
            </p:cNvPr>
            <p:cNvSpPr txBox="1"/>
            <p:nvPr/>
          </p:nvSpPr>
          <p:spPr>
            <a:xfrm>
              <a:off x="1456229" y="8524744"/>
              <a:ext cx="43323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uxin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53B841EA-2F81-F7F0-9D5C-FED1735C859C}"/>
                </a:ext>
              </a:extLst>
            </p:cNvPr>
            <p:cNvSpPr txBox="1"/>
            <p:nvPr/>
          </p:nvSpPr>
          <p:spPr>
            <a:xfrm rot="16200000">
              <a:off x="177279" y="7759303"/>
              <a:ext cx="121455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% development stage</a:t>
              </a:r>
            </a:p>
          </p:txBody>
        </p:sp>
        <p:cxnSp>
          <p:nvCxnSpPr>
            <p:cNvPr id="186" name="Straight Connector 185">
              <a:extLst>
                <a:ext uri="{FF2B5EF4-FFF2-40B4-BE49-F238E27FC236}">
                  <a16:creationId xmlns:a16="http://schemas.microsoft.com/office/drawing/2014/main" id="{1F3E68AF-7D42-EC1A-4287-72B0241B7BA9}"/>
                </a:ext>
              </a:extLst>
            </p:cNvPr>
            <p:cNvCxnSpPr>
              <a:cxnSpLocks/>
            </p:cNvCxnSpPr>
            <p:nvPr/>
          </p:nvCxnSpPr>
          <p:spPr>
            <a:xfrm>
              <a:off x="994306" y="8723665"/>
              <a:ext cx="93441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CF36356C-424A-FCEB-13C2-82A120215FE9}"/>
                </a:ext>
              </a:extLst>
            </p:cNvPr>
            <p:cNvSpPr txBox="1"/>
            <p:nvPr/>
          </p:nvSpPr>
          <p:spPr>
            <a:xfrm>
              <a:off x="1084718" y="8709825"/>
              <a:ext cx="833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omatic TIR1, no AID* tag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E363A7F0-D161-B9E5-4562-35E03923469A}"/>
                </a:ext>
              </a:extLst>
            </p:cNvPr>
            <p:cNvSpPr txBox="1"/>
            <p:nvPr/>
          </p:nvSpPr>
          <p:spPr>
            <a:xfrm rot="16200000">
              <a:off x="-151956" y="6481159"/>
              <a:ext cx="109713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omatic TIR1 alone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3FC8FBCE-6753-F882-B01C-D05EB1150EE5}"/>
                </a:ext>
              </a:extLst>
            </p:cNvPr>
            <p:cNvSpPr txBox="1"/>
            <p:nvPr/>
          </p:nvSpPr>
          <p:spPr>
            <a:xfrm>
              <a:off x="501075" y="5902628"/>
              <a:ext cx="108053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ehicle 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E43D9339-9D7B-BBD4-A34E-EB532CAAA062}"/>
                </a:ext>
              </a:extLst>
            </p:cNvPr>
            <p:cNvSpPr txBox="1"/>
            <p:nvPr/>
          </p:nvSpPr>
          <p:spPr>
            <a:xfrm>
              <a:off x="1597483" y="5903828"/>
              <a:ext cx="107632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 mM auxin </a:t>
              </a:r>
            </a:p>
          </p:txBody>
        </p:sp>
        <p:sp>
          <p:nvSpPr>
            <p:cNvPr id="195" name="Rectangle 194">
              <a:extLst>
                <a:ext uri="{FF2B5EF4-FFF2-40B4-BE49-F238E27FC236}">
                  <a16:creationId xmlns:a16="http://schemas.microsoft.com/office/drawing/2014/main" id="{35E432FE-D66F-1D50-9A58-0798C561B642}"/>
                </a:ext>
              </a:extLst>
            </p:cNvPr>
            <p:cNvSpPr/>
            <p:nvPr/>
          </p:nvSpPr>
          <p:spPr>
            <a:xfrm>
              <a:off x="845660" y="7172553"/>
              <a:ext cx="148325" cy="13735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4A92EF8D-9A06-FFAC-1BFC-38622643B0F8}"/>
                </a:ext>
              </a:extLst>
            </p:cNvPr>
            <p:cNvSpPr txBox="1"/>
            <p:nvPr/>
          </p:nvSpPr>
          <p:spPr>
            <a:xfrm>
              <a:off x="761191" y="7167222"/>
              <a:ext cx="3321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2598A332-D906-C43B-1F81-3D96BB554B5F}"/>
                </a:ext>
              </a:extLst>
            </p:cNvPr>
            <p:cNvSpPr txBox="1"/>
            <p:nvPr/>
          </p:nvSpPr>
          <p:spPr>
            <a:xfrm>
              <a:off x="799909" y="7406948"/>
              <a:ext cx="3321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98" name="Left Bracket 197">
              <a:extLst>
                <a:ext uri="{FF2B5EF4-FFF2-40B4-BE49-F238E27FC236}">
                  <a16:creationId xmlns:a16="http://schemas.microsoft.com/office/drawing/2014/main" id="{A8814FD1-543D-1556-3CD5-A180683D16B4}"/>
                </a:ext>
              </a:extLst>
            </p:cNvPr>
            <p:cNvSpPr/>
            <p:nvPr/>
          </p:nvSpPr>
          <p:spPr>
            <a:xfrm rot="5400000">
              <a:off x="1424440" y="7008849"/>
              <a:ext cx="50219" cy="359288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C9EB94DE-0FA1-5091-998A-56C9F1A4E107}"/>
                </a:ext>
              </a:extLst>
            </p:cNvPr>
            <p:cNvSpPr txBox="1"/>
            <p:nvPr/>
          </p:nvSpPr>
          <p:spPr>
            <a:xfrm>
              <a:off x="1314149" y="7020312"/>
              <a:ext cx="81553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71811087-850B-7B32-FA37-ADAA5F9E2391}"/>
                </a:ext>
              </a:extLst>
            </p:cNvPr>
            <p:cNvSpPr txBox="1"/>
            <p:nvPr/>
          </p:nvSpPr>
          <p:spPr>
            <a:xfrm>
              <a:off x="802319" y="7656978"/>
              <a:ext cx="3321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E43E4DC9-ECE7-B164-CFBA-4E1B9B592796}"/>
                </a:ext>
              </a:extLst>
            </p:cNvPr>
            <p:cNvSpPr txBox="1"/>
            <p:nvPr/>
          </p:nvSpPr>
          <p:spPr>
            <a:xfrm>
              <a:off x="802319" y="7914077"/>
              <a:ext cx="3321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B2520F1A-412D-6DB3-B4D6-DE1B676B750F}"/>
                </a:ext>
              </a:extLst>
            </p:cNvPr>
            <p:cNvSpPr txBox="1"/>
            <p:nvPr/>
          </p:nvSpPr>
          <p:spPr>
            <a:xfrm>
              <a:off x="802319" y="8165919"/>
              <a:ext cx="3321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6396FEE6-A111-0F11-5ACA-B3274A1852B2}"/>
                </a:ext>
              </a:extLst>
            </p:cNvPr>
            <p:cNvSpPr txBox="1"/>
            <p:nvPr/>
          </p:nvSpPr>
          <p:spPr>
            <a:xfrm>
              <a:off x="848476" y="8402151"/>
              <a:ext cx="3321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81FC6E84-9CBA-DD1C-CE04-544DE2DBFB6C}"/>
                </a:ext>
              </a:extLst>
            </p:cNvPr>
            <p:cNvSpPr txBox="1"/>
            <p:nvPr/>
          </p:nvSpPr>
          <p:spPr>
            <a:xfrm>
              <a:off x="1109138" y="8339353"/>
              <a:ext cx="3761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46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A0CE9A04-DE21-ED78-99CC-E7D73A41714D}"/>
                </a:ext>
              </a:extLst>
            </p:cNvPr>
            <p:cNvSpPr txBox="1"/>
            <p:nvPr/>
          </p:nvSpPr>
          <p:spPr>
            <a:xfrm>
              <a:off x="1478503" y="8339353"/>
              <a:ext cx="6250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88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D10DCA33-0149-A85C-E3BA-CC38A4CE2697}"/>
                </a:ext>
              </a:extLst>
            </p:cNvPr>
            <p:cNvSpPr txBox="1"/>
            <p:nvPr/>
          </p:nvSpPr>
          <p:spPr>
            <a:xfrm>
              <a:off x="488085" y="6082766"/>
              <a:ext cx="2269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6D255E4C-547D-573B-EB90-B47323640F97}"/>
                </a:ext>
              </a:extLst>
            </p:cNvPr>
            <p:cNvSpPr txBox="1"/>
            <p:nvPr/>
          </p:nvSpPr>
          <p:spPr>
            <a:xfrm>
              <a:off x="1585875" y="6081732"/>
              <a:ext cx="2269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F187034E-7C93-06B8-9873-DC97F1BC4FF4}"/>
                </a:ext>
              </a:extLst>
            </p:cNvPr>
            <p:cNvSpPr txBox="1"/>
            <p:nvPr/>
          </p:nvSpPr>
          <p:spPr>
            <a:xfrm>
              <a:off x="467133" y="6978071"/>
              <a:ext cx="2269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55611EB6-AFDE-7514-34B5-0965332EEC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78047" y="604632"/>
            <a:ext cx="5095763" cy="94118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2F6A88BD-42FF-284E-9B05-27DDD1CC37FA}"/>
              </a:ext>
            </a:extLst>
          </p:cNvPr>
          <p:cNvSpPr txBox="1"/>
          <p:nvPr/>
        </p:nvSpPr>
        <p:spPr>
          <a:xfrm flipH="1">
            <a:off x="207859" y="350116"/>
            <a:ext cx="277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61227-87FA-C67C-B04B-3E224ACDF07C}"/>
              </a:ext>
            </a:extLst>
          </p:cNvPr>
          <p:cNvSpPr txBox="1"/>
          <p:nvPr/>
        </p:nvSpPr>
        <p:spPr>
          <a:xfrm>
            <a:off x="250835" y="1442837"/>
            <a:ext cx="1723863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tt</a:t>
            </a:r>
            <a:r>
              <a:rPr lang="en-US" sz="600" dirty="0">
                <a:solidFill>
                  <a:srgbClr val="000000"/>
                </a:solidFill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cc</a:t>
            </a:r>
            <a:r>
              <a:rPr lang="en-US" sz="600" u="sng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tg^ga</a:t>
            </a:r>
            <a:r>
              <a:rPr lang="en-US" sz="600" u="sng" cap="all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TGCGACCTGCTGCC</a:t>
            </a:r>
            <a:r>
              <a:rPr lang="en-US" sz="600" cap="all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C</a:t>
            </a:r>
            <a:r>
              <a:rPr lang="en-US" sz="600" dirty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n-US" sz="600" b="1" i="1" dirty="0">
              <a:solidFill>
                <a:srgbClr val="0070C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36CBC4B8-E478-3C4B-CCDF-7E9D2C6444F1}"/>
              </a:ext>
            </a:extLst>
          </p:cNvPr>
          <p:cNvSpPr txBox="1"/>
          <p:nvPr/>
        </p:nvSpPr>
        <p:spPr>
          <a:xfrm>
            <a:off x="473363" y="782453"/>
            <a:ext cx="7475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wts-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5DC9345-A980-D8D3-6C52-FA98B36C9D94}"/>
              </a:ext>
            </a:extLst>
          </p:cNvPr>
          <p:cNvSpPr txBox="1"/>
          <p:nvPr/>
        </p:nvSpPr>
        <p:spPr>
          <a:xfrm>
            <a:off x="5864931" y="484834"/>
            <a:ext cx="764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 bp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790A482-A1FF-42E0-8DBA-5A1C8AFD8CDB}"/>
              </a:ext>
            </a:extLst>
          </p:cNvPr>
          <p:cNvSpPr/>
          <p:nvPr/>
        </p:nvSpPr>
        <p:spPr>
          <a:xfrm>
            <a:off x="3664308" y="1258883"/>
            <a:ext cx="1405899" cy="427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9F766B5-4B41-CF9A-E3D4-4F5715E959A2}"/>
              </a:ext>
            </a:extLst>
          </p:cNvPr>
          <p:cNvCxnSpPr>
            <a:cxnSpLocks/>
          </p:cNvCxnSpPr>
          <p:nvPr/>
        </p:nvCxnSpPr>
        <p:spPr>
          <a:xfrm>
            <a:off x="3727450" y="1277876"/>
            <a:ext cx="578448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0" name="Rectangle 39">
            <a:extLst>
              <a:ext uri="{FF2B5EF4-FFF2-40B4-BE49-F238E27FC236}">
                <a16:creationId xmlns:a16="http://schemas.microsoft.com/office/drawing/2014/main" id="{594A9845-9A2E-A52C-DD22-C4E48332BDAC}"/>
              </a:ext>
            </a:extLst>
          </p:cNvPr>
          <p:cNvSpPr/>
          <p:nvPr/>
        </p:nvSpPr>
        <p:spPr>
          <a:xfrm>
            <a:off x="1026557" y="540968"/>
            <a:ext cx="653435" cy="276999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39CE482-B110-9EF2-52B1-9709BD762FFF}"/>
              </a:ext>
            </a:extLst>
          </p:cNvPr>
          <p:cNvSpPr txBox="1"/>
          <p:nvPr/>
        </p:nvSpPr>
        <p:spPr>
          <a:xfrm>
            <a:off x="3780948" y="1271571"/>
            <a:ext cx="718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△1</a:t>
            </a:r>
            <a:r>
              <a:rPr lang="en-US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m408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288D4AB-8097-4E8D-AC4B-A1DC785FDA2C}"/>
              </a:ext>
            </a:extLst>
          </p:cNvPr>
          <p:cNvSpPr txBox="1"/>
          <p:nvPr/>
        </p:nvSpPr>
        <p:spPr>
          <a:xfrm>
            <a:off x="4382971" y="1271571"/>
            <a:ext cx="8813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△2</a:t>
            </a:r>
            <a:r>
              <a:rPr lang="en-US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k753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7815A85-C8C5-633D-524D-7B43FE624217}"/>
              </a:ext>
            </a:extLst>
          </p:cNvPr>
          <p:cNvCxnSpPr>
            <a:cxnSpLocks/>
          </p:cNvCxnSpPr>
          <p:nvPr/>
        </p:nvCxnSpPr>
        <p:spPr>
          <a:xfrm>
            <a:off x="4245160" y="679467"/>
            <a:ext cx="1087895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16DE894A-7D7D-F7CF-449D-BDD40FDE2056}"/>
              </a:ext>
            </a:extLst>
          </p:cNvPr>
          <p:cNvSpPr txBox="1"/>
          <p:nvPr/>
        </p:nvSpPr>
        <p:spPr>
          <a:xfrm>
            <a:off x="4323872" y="396290"/>
            <a:ext cx="9717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/T Kinas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EE9E07E-FFA0-64D8-54AF-F294755F1D13}"/>
              </a:ext>
            </a:extLst>
          </p:cNvPr>
          <p:cNvSpPr txBox="1"/>
          <p:nvPr/>
        </p:nvSpPr>
        <p:spPr>
          <a:xfrm>
            <a:off x="746561" y="1641976"/>
            <a:ext cx="10320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436 </a:t>
            </a:r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800" b="1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D789896C-4324-6CD3-614A-3013F3AE8A3E}"/>
              </a:ext>
            </a:extLst>
          </p:cNvPr>
          <p:cNvCxnSpPr>
            <a:cxnSpLocks/>
          </p:cNvCxnSpPr>
          <p:nvPr/>
        </p:nvCxnSpPr>
        <p:spPr>
          <a:xfrm flipH="1">
            <a:off x="361798" y="1048656"/>
            <a:ext cx="830263" cy="434839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736332CF-83AA-D49E-318A-34C89AB6F26B}"/>
              </a:ext>
            </a:extLst>
          </p:cNvPr>
          <p:cNvCxnSpPr>
            <a:cxnSpLocks/>
          </p:cNvCxnSpPr>
          <p:nvPr/>
        </p:nvCxnSpPr>
        <p:spPr>
          <a:xfrm>
            <a:off x="1231776" y="1048656"/>
            <a:ext cx="475079" cy="452635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3790B799-05E0-5AC1-7542-5EADDD12772D}"/>
              </a:ext>
            </a:extLst>
          </p:cNvPr>
          <p:cNvSpPr txBox="1"/>
          <p:nvPr/>
        </p:nvSpPr>
        <p:spPr>
          <a:xfrm>
            <a:off x="228608" y="1795444"/>
            <a:ext cx="3962240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tt</a:t>
            </a:r>
            <a:r>
              <a:rPr lang="en-US" sz="600" dirty="0">
                <a:solidFill>
                  <a:srgbClr val="000000"/>
                </a:solidFill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cc</a:t>
            </a:r>
            <a:r>
              <a:rPr lang="en-US" sz="600" u="sng" strike="sngStrike" dirty="0">
                <a:solidFill>
                  <a:schemeClr val="bg1">
                    <a:lumMod val="85000"/>
                  </a:schemeClr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tg</a:t>
            </a:r>
            <a:r>
              <a:rPr lang="en-US" sz="600" u="sng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^</a:t>
            </a:r>
            <a:r>
              <a:rPr lang="en-US" sz="600" dirty="0">
                <a:solidFill>
                  <a:srgbClr val="333333"/>
                </a:solidFill>
                <a:effectLst/>
                <a:highlight>
                  <a:srgbClr val="FF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GGAAGTTTGTCCAGAGCAGAGGTGACTAAGTGATAAGCTAGC</a:t>
            </a:r>
            <a:r>
              <a:rPr lang="en-US" sz="600" u="sng" strike="sngStrike" dirty="0">
                <a:solidFill>
                  <a:schemeClr val="bg1">
                    <a:lumMod val="85000"/>
                  </a:schemeClr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ga</a:t>
            </a:r>
            <a:r>
              <a:rPr lang="en-US" sz="600" u="sng" strike="sngStrike" cap="all" dirty="0">
                <a:solidFill>
                  <a:schemeClr val="bg1">
                    <a:lumMod val="85000"/>
                  </a:schemeClr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</a:t>
            </a:r>
            <a:r>
              <a:rPr lang="en-US" sz="600" u="sng" cap="all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GCGACCTGCTGCC</a:t>
            </a:r>
            <a:r>
              <a:rPr lang="en-US" sz="600" cap="all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C</a:t>
            </a:r>
            <a:r>
              <a:rPr lang="en-US" sz="600" dirty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n-US" sz="600" b="1" i="1" dirty="0">
              <a:solidFill>
                <a:srgbClr val="0070C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F56DC72C-E2B0-2B6A-B95E-A82E3020FB72}"/>
              </a:ext>
            </a:extLst>
          </p:cNvPr>
          <p:cNvCxnSpPr>
            <a:cxnSpLocks/>
          </p:cNvCxnSpPr>
          <p:nvPr/>
        </p:nvCxnSpPr>
        <p:spPr>
          <a:xfrm>
            <a:off x="1002367" y="1586845"/>
            <a:ext cx="1803684" cy="249257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750BBA9A-BB1E-747A-F3B2-243C34FF45EE}"/>
              </a:ext>
            </a:extLst>
          </p:cNvPr>
          <p:cNvCxnSpPr>
            <a:cxnSpLocks/>
          </p:cNvCxnSpPr>
          <p:nvPr/>
        </p:nvCxnSpPr>
        <p:spPr>
          <a:xfrm>
            <a:off x="665966" y="1586845"/>
            <a:ext cx="166754" cy="249257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05A1A682-75B0-D67D-933F-1DF67EF2A6D0}"/>
              </a:ext>
            </a:extLst>
          </p:cNvPr>
          <p:cNvSpPr txBox="1"/>
          <p:nvPr/>
        </p:nvSpPr>
        <p:spPr>
          <a:xfrm>
            <a:off x="895205" y="1206881"/>
            <a:ext cx="61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51D44B11-17C7-507A-8FBE-C4D6AE8FCF56}"/>
              </a:ext>
            </a:extLst>
          </p:cNvPr>
          <p:cNvSpPr/>
          <p:nvPr/>
        </p:nvSpPr>
        <p:spPr>
          <a:xfrm>
            <a:off x="711956" y="519649"/>
            <a:ext cx="1087895" cy="178833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T2::2xMyc::AID*</a:t>
            </a:r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AA76742D-BE4A-D06B-FCCC-6004C9DD8B8D}"/>
              </a:ext>
            </a:extLst>
          </p:cNvPr>
          <p:cNvCxnSpPr>
            <a:cxnSpLocks/>
          </p:cNvCxnSpPr>
          <p:nvPr/>
        </p:nvCxnSpPr>
        <p:spPr>
          <a:xfrm>
            <a:off x="712043" y="699284"/>
            <a:ext cx="519733" cy="1214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346EFEA6-0199-EF77-2D80-1968F3C5D18D}"/>
              </a:ext>
            </a:extLst>
          </p:cNvPr>
          <p:cNvCxnSpPr>
            <a:cxnSpLocks/>
          </p:cNvCxnSpPr>
          <p:nvPr/>
        </p:nvCxnSpPr>
        <p:spPr>
          <a:xfrm flipV="1">
            <a:off x="1227914" y="699202"/>
            <a:ext cx="566752" cy="1179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DE29B3A2-76BB-E29B-B5FD-365B4E15DA12}"/>
              </a:ext>
            </a:extLst>
          </p:cNvPr>
          <p:cNvCxnSpPr>
            <a:cxnSpLocks/>
          </p:cNvCxnSpPr>
          <p:nvPr/>
        </p:nvCxnSpPr>
        <p:spPr>
          <a:xfrm flipV="1">
            <a:off x="1226967" y="817967"/>
            <a:ext cx="0" cy="489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9B4F888E-9439-741A-9C8E-4FF5EDA97A0D}"/>
              </a:ext>
            </a:extLst>
          </p:cNvPr>
          <p:cNvSpPr/>
          <p:nvPr/>
        </p:nvSpPr>
        <p:spPr>
          <a:xfrm>
            <a:off x="1384779" y="1994873"/>
            <a:ext cx="681985" cy="193836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OP-IN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5C4B557-CE3F-38E8-6610-0A999EA20EA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6324" t="18028" r="13122" b="34276"/>
          <a:stretch>
            <a:fillRect/>
          </a:stretch>
        </p:blipFill>
        <p:spPr>
          <a:xfrm>
            <a:off x="1027057" y="3797142"/>
            <a:ext cx="1344264" cy="1231614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DA1CF26C-B3EE-7707-02FD-B6BABFDDD3D7}"/>
              </a:ext>
            </a:extLst>
          </p:cNvPr>
          <p:cNvSpPr txBox="1"/>
          <p:nvPr/>
        </p:nvSpPr>
        <p:spPr>
          <a:xfrm>
            <a:off x="747875" y="5196684"/>
            <a:ext cx="20466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wts-1:    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(re436)</a:t>
            </a:r>
            <a:r>
              <a:rPr lang="en-US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△2(ok753)</a:t>
            </a:r>
          </a:p>
          <a:p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7EE5DEA-2738-3D8D-3644-F3FEF8F86DA3}"/>
              </a:ext>
            </a:extLst>
          </p:cNvPr>
          <p:cNvSpPr txBox="1"/>
          <p:nvPr/>
        </p:nvSpPr>
        <p:spPr>
          <a:xfrm>
            <a:off x="736635" y="5025969"/>
            <a:ext cx="2130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NAi:   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trl    wts-1   ctrl     wts-1 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D5EFEC12-C440-9ADE-6623-4B412D67569C}"/>
              </a:ext>
            </a:extLst>
          </p:cNvPr>
          <p:cNvCxnSpPr>
            <a:cxnSpLocks/>
          </p:cNvCxnSpPr>
          <p:nvPr/>
        </p:nvCxnSpPr>
        <p:spPr>
          <a:xfrm>
            <a:off x="1103903" y="5208482"/>
            <a:ext cx="5992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72D163BB-6D21-D1E0-A94F-84722E904FE8}"/>
              </a:ext>
            </a:extLst>
          </p:cNvPr>
          <p:cNvCxnSpPr>
            <a:cxnSpLocks/>
          </p:cNvCxnSpPr>
          <p:nvPr/>
        </p:nvCxnSpPr>
        <p:spPr>
          <a:xfrm>
            <a:off x="1768689" y="5208482"/>
            <a:ext cx="5882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98516197-13F9-417E-6730-D51F9BADA932}"/>
              </a:ext>
            </a:extLst>
          </p:cNvPr>
          <p:cNvSpPr txBox="1"/>
          <p:nvPr/>
        </p:nvSpPr>
        <p:spPr>
          <a:xfrm rot="16200000">
            <a:off x="206315" y="4305074"/>
            <a:ext cx="121455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% development stag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E225D8C-D998-9C29-2017-70E67AA8686D}"/>
              </a:ext>
            </a:extLst>
          </p:cNvPr>
          <p:cNvSpPr txBox="1"/>
          <p:nvPr/>
        </p:nvSpPr>
        <p:spPr>
          <a:xfrm>
            <a:off x="886610" y="4905694"/>
            <a:ext cx="2127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CF8F298-133E-7933-1B93-2DFFFDA659D9}"/>
              </a:ext>
            </a:extLst>
          </p:cNvPr>
          <p:cNvSpPr txBox="1"/>
          <p:nvPr/>
        </p:nvSpPr>
        <p:spPr>
          <a:xfrm>
            <a:off x="847228" y="4671927"/>
            <a:ext cx="4310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1AFBA4E-04C0-3851-9F63-C1C17E519302}"/>
              </a:ext>
            </a:extLst>
          </p:cNvPr>
          <p:cNvSpPr txBox="1"/>
          <p:nvPr/>
        </p:nvSpPr>
        <p:spPr>
          <a:xfrm>
            <a:off x="839733" y="4431368"/>
            <a:ext cx="3295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9F7D04F-AFC9-E40D-0DBF-5962D558F340}"/>
              </a:ext>
            </a:extLst>
          </p:cNvPr>
          <p:cNvSpPr txBox="1"/>
          <p:nvPr/>
        </p:nvSpPr>
        <p:spPr>
          <a:xfrm>
            <a:off x="841813" y="4196530"/>
            <a:ext cx="342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11A47F4-0BA0-C015-4896-3849FA78D49C}"/>
              </a:ext>
            </a:extLst>
          </p:cNvPr>
          <p:cNvSpPr txBox="1"/>
          <p:nvPr/>
        </p:nvSpPr>
        <p:spPr>
          <a:xfrm>
            <a:off x="841812" y="3949967"/>
            <a:ext cx="31992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9305CF2-F4DC-2834-9233-C7F16896F93F}"/>
              </a:ext>
            </a:extLst>
          </p:cNvPr>
          <p:cNvSpPr txBox="1"/>
          <p:nvPr/>
        </p:nvSpPr>
        <p:spPr>
          <a:xfrm>
            <a:off x="802208" y="3715356"/>
            <a:ext cx="32074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31728BC2-7DE0-4557-6545-060F253C6A3A}"/>
              </a:ext>
            </a:extLst>
          </p:cNvPr>
          <p:cNvCxnSpPr/>
          <p:nvPr/>
        </p:nvCxnSpPr>
        <p:spPr>
          <a:xfrm>
            <a:off x="1234182" y="3769477"/>
            <a:ext cx="330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CB2D1012-ACF5-2D5E-E9AD-3A57EEF23A2D}"/>
              </a:ext>
            </a:extLst>
          </p:cNvPr>
          <p:cNvCxnSpPr/>
          <p:nvPr/>
        </p:nvCxnSpPr>
        <p:spPr>
          <a:xfrm>
            <a:off x="1843204" y="3769477"/>
            <a:ext cx="330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>
            <a:extLst>
              <a:ext uri="{FF2B5EF4-FFF2-40B4-BE49-F238E27FC236}">
                <a16:creationId xmlns:a16="http://schemas.microsoft.com/office/drawing/2014/main" id="{7749C1AB-F3C1-D0D8-0072-E57D03AEA828}"/>
              </a:ext>
            </a:extLst>
          </p:cNvPr>
          <p:cNvSpPr txBox="1"/>
          <p:nvPr/>
        </p:nvSpPr>
        <p:spPr>
          <a:xfrm>
            <a:off x="1256506" y="3647367"/>
            <a:ext cx="307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DAB3C37A-3C5A-4B13-2E4F-2780F6C82AB3}"/>
              </a:ext>
            </a:extLst>
          </p:cNvPr>
          <p:cNvSpPr txBox="1"/>
          <p:nvPr/>
        </p:nvSpPr>
        <p:spPr>
          <a:xfrm>
            <a:off x="1886831" y="3651187"/>
            <a:ext cx="307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D38C7C1-CEAA-709B-9254-286737D274E2}"/>
              </a:ext>
            </a:extLst>
          </p:cNvPr>
          <p:cNvSpPr txBox="1"/>
          <p:nvPr/>
        </p:nvSpPr>
        <p:spPr>
          <a:xfrm>
            <a:off x="1122131" y="4817440"/>
            <a:ext cx="3149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D6E8FA0-1166-42F3-9FE9-55E750738827}"/>
              </a:ext>
            </a:extLst>
          </p:cNvPr>
          <p:cNvSpPr txBox="1"/>
          <p:nvPr/>
        </p:nvSpPr>
        <p:spPr>
          <a:xfrm>
            <a:off x="1420059" y="4817440"/>
            <a:ext cx="3149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51B3F6F-3871-985D-88D6-7C5D5B1EDCC5}"/>
              </a:ext>
            </a:extLst>
          </p:cNvPr>
          <p:cNvSpPr txBox="1"/>
          <p:nvPr/>
        </p:nvSpPr>
        <p:spPr>
          <a:xfrm>
            <a:off x="1712342" y="4817440"/>
            <a:ext cx="3149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6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F96021B-3FFC-17CA-FE5F-610A66E84934}"/>
              </a:ext>
            </a:extLst>
          </p:cNvPr>
          <p:cNvSpPr txBox="1"/>
          <p:nvPr/>
        </p:nvSpPr>
        <p:spPr>
          <a:xfrm>
            <a:off x="2022081" y="4817440"/>
            <a:ext cx="3149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2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C7EA2691-28CB-D510-3246-EC5E160489A4}"/>
              </a:ext>
            </a:extLst>
          </p:cNvPr>
          <p:cNvSpPr txBox="1"/>
          <p:nvPr/>
        </p:nvSpPr>
        <p:spPr>
          <a:xfrm flipH="1">
            <a:off x="207859" y="3599020"/>
            <a:ext cx="277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182FB7F-7419-1C91-32FF-B386627DDF7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5414" t="83062" r="23287" b="3326"/>
          <a:stretch>
            <a:fillRect/>
          </a:stretch>
        </p:blipFill>
        <p:spPr>
          <a:xfrm>
            <a:off x="2295668" y="3743519"/>
            <a:ext cx="414036" cy="637277"/>
          </a:xfrm>
          <a:prstGeom prst="rect">
            <a:avLst/>
          </a:prstGeom>
        </p:spPr>
      </p:pic>
      <p:pic>
        <p:nvPicPr>
          <p:cNvPr id="132" name="Picture 131">
            <a:extLst>
              <a:ext uri="{FF2B5EF4-FFF2-40B4-BE49-F238E27FC236}">
                <a16:creationId xmlns:a16="http://schemas.microsoft.com/office/drawing/2014/main" id="{3D01B868-2B58-F09F-8901-1E6034D3DCC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707" t="17003" r="23814" b="38780"/>
          <a:stretch>
            <a:fillRect/>
          </a:stretch>
        </p:blipFill>
        <p:spPr>
          <a:xfrm>
            <a:off x="4636229" y="3838311"/>
            <a:ext cx="1103623" cy="1165978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690E1AD1-DFE1-C6BD-6450-61CAEF1968DC}"/>
              </a:ext>
            </a:extLst>
          </p:cNvPr>
          <p:cNvGrpSpPr/>
          <p:nvPr/>
        </p:nvGrpSpPr>
        <p:grpSpPr>
          <a:xfrm>
            <a:off x="3882678" y="3577746"/>
            <a:ext cx="2348212" cy="1967490"/>
            <a:chOff x="151822" y="6506722"/>
            <a:chExt cx="2348212" cy="1967490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42986D3-8CB3-41E1-E2F0-5FAB12CDB978}"/>
                </a:ext>
              </a:extLst>
            </p:cNvPr>
            <p:cNvSpPr txBox="1"/>
            <p:nvPr/>
          </p:nvSpPr>
          <p:spPr>
            <a:xfrm>
              <a:off x="402111" y="7932787"/>
              <a:ext cx="79921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reatment: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ECB3384-91B9-8C66-D53E-860FBFAC4C5B}"/>
                </a:ext>
              </a:extLst>
            </p:cNvPr>
            <p:cNvSpPr txBox="1"/>
            <p:nvPr/>
          </p:nvSpPr>
          <p:spPr>
            <a:xfrm>
              <a:off x="151822" y="8258768"/>
              <a:ext cx="23482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ID*::WTS-1 + germline expressed TIR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CC0BFA1-882A-91C6-51A1-7EA817930EA2}"/>
                </a:ext>
              </a:extLst>
            </p:cNvPr>
            <p:cNvSpPr txBox="1"/>
            <p:nvPr/>
          </p:nvSpPr>
          <p:spPr>
            <a:xfrm>
              <a:off x="837241" y="7902075"/>
              <a:ext cx="822877" cy="196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ehicle +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2BF0242-439B-5A8E-DB35-ACE7D1320183}"/>
                </a:ext>
              </a:extLst>
            </p:cNvPr>
            <p:cNvSpPr txBox="1"/>
            <p:nvPr/>
          </p:nvSpPr>
          <p:spPr>
            <a:xfrm>
              <a:off x="940803" y="8042947"/>
              <a:ext cx="766127" cy="196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ctrl(RNAi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6D5B5A1-24B0-660D-40B4-C2CD62C06E3E}"/>
                </a:ext>
              </a:extLst>
            </p:cNvPr>
            <p:cNvSpPr txBox="1"/>
            <p:nvPr/>
          </p:nvSpPr>
          <p:spPr>
            <a:xfrm>
              <a:off x="1408216" y="8034469"/>
              <a:ext cx="677332" cy="196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wts-1(RNAi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21C13F5-4010-C12C-44DB-AA1D29F587AF}"/>
                </a:ext>
              </a:extLst>
            </p:cNvPr>
            <p:cNvSpPr txBox="1"/>
            <p:nvPr/>
          </p:nvSpPr>
          <p:spPr>
            <a:xfrm>
              <a:off x="1305335" y="7898310"/>
              <a:ext cx="822877" cy="196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uxin +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3176ABE-5169-3149-361E-4962D6C39C50}"/>
                </a:ext>
              </a:extLst>
            </p:cNvPr>
            <p:cNvSpPr txBox="1"/>
            <p:nvPr/>
          </p:nvSpPr>
          <p:spPr>
            <a:xfrm>
              <a:off x="673642" y="6690549"/>
              <a:ext cx="469884" cy="180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D125AE4-EC10-2596-E020-57C7060C5068}"/>
                </a:ext>
              </a:extLst>
            </p:cNvPr>
            <p:cNvSpPr txBox="1"/>
            <p:nvPr/>
          </p:nvSpPr>
          <p:spPr>
            <a:xfrm>
              <a:off x="717807" y="6911015"/>
              <a:ext cx="469884" cy="180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F8C5BFF-0350-CB7C-409A-2F3FBE541944}"/>
                </a:ext>
              </a:extLst>
            </p:cNvPr>
            <p:cNvSpPr txBox="1"/>
            <p:nvPr/>
          </p:nvSpPr>
          <p:spPr>
            <a:xfrm>
              <a:off x="722070" y="7137505"/>
              <a:ext cx="469884" cy="180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152CB22-3339-E397-4E98-5B9FEF18EFD1}"/>
                </a:ext>
              </a:extLst>
            </p:cNvPr>
            <p:cNvSpPr txBox="1"/>
            <p:nvPr/>
          </p:nvSpPr>
          <p:spPr>
            <a:xfrm>
              <a:off x="720098" y="7362581"/>
              <a:ext cx="469884" cy="180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F55E7D5-7CA7-3738-657F-5C2310BE42B7}"/>
                </a:ext>
              </a:extLst>
            </p:cNvPr>
            <p:cNvSpPr txBox="1"/>
            <p:nvPr/>
          </p:nvSpPr>
          <p:spPr>
            <a:xfrm>
              <a:off x="720508" y="7585355"/>
              <a:ext cx="469884" cy="180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1065EC57-CD05-F503-F932-609B73AF0B5E}"/>
                </a:ext>
              </a:extLst>
            </p:cNvPr>
            <p:cNvSpPr txBox="1"/>
            <p:nvPr/>
          </p:nvSpPr>
          <p:spPr>
            <a:xfrm>
              <a:off x="716152" y="7795950"/>
              <a:ext cx="469884" cy="180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 0</a:t>
              </a:r>
            </a:p>
          </p:txBody>
        </p:sp>
        <p:sp>
          <p:nvSpPr>
            <p:cNvPr id="49" name="Left Bracket 48">
              <a:extLst>
                <a:ext uri="{FF2B5EF4-FFF2-40B4-BE49-F238E27FC236}">
                  <a16:creationId xmlns:a16="http://schemas.microsoft.com/office/drawing/2014/main" id="{DD5B6526-B520-8939-C2B4-BB582CB7BC05}"/>
                </a:ext>
              </a:extLst>
            </p:cNvPr>
            <p:cNvSpPr/>
            <p:nvPr/>
          </p:nvSpPr>
          <p:spPr>
            <a:xfrm rot="5400000">
              <a:off x="1433970" y="6508968"/>
              <a:ext cx="44891" cy="407405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D25DBEBB-E125-426D-0E4F-0FC4AEB3FACC}"/>
                </a:ext>
              </a:extLst>
            </p:cNvPr>
            <p:cNvSpPr txBox="1"/>
            <p:nvPr/>
          </p:nvSpPr>
          <p:spPr>
            <a:xfrm>
              <a:off x="1310969" y="6506722"/>
              <a:ext cx="452846" cy="2115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E77C6524-7A47-51E7-087A-C259B920B039}"/>
                </a:ext>
              </a:extLst>
            </p:cNvPr>
            <p:cNvSpPr txBox="1"/>
            <p:nvPr/>
          </p:nvSpPr>
          <p:spPr>
            <a:xfrm rot="16200000">
              <a:off x="-8314" y="7236135"/>
              <a:ext cx="132591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% developmental stage</a:t>
              </a: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B2BF226F-69B2-E678-1239-A063A4F96A28}"/>
                </a:ext>
              </a:extLst>
            </p:cNvPr>
            <p:cNvCxnSpPr>
              <a:cxnSpLocks/>
            </p:cNvCxnSpPr>
            <p:nvPr/>
          </p:nvCxnSpPr>
          <p:spPr>
            <a:xfrm>
              <a:off x="890884" y="8250220"/>
              <a:ext cx="111840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87B5F7E8-F6E8-565A-1EA5-88C75B8DC729}"/>
              </a:ext>
            </a:extLst>
          </p:cNvPr>
          <p:cNvSpPr txBox="1"/>
          <p:nvPr/>
        </p:nvSpPr>
        <p:spPr>
          <a:xfrm>
            <a:off x="4797739" y="4774534"/>
            <a:ext cx="3900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29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9A10657-E5F4-DC39-50F3-98E974368847}"/>
              </a:ext>
            </a:extLst>
          </p:cNvPr>
          <p:cNvSpPr txBox="1"/>
          <p:nvPr/>
        </p:nvSpPr>
        <p:spPr>
          <a:xfrm>
            <a:off x="5250763" y="4774534"/>
            <a:ext cx="7052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42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B60678FE-EE3B-5C0A-46D8-8C6E4294C151}"/>
              </a:ext>
            </a:extLst>
          </p:cNvPr>
          <p:cNvSpPr txBox="1"/>
          <p:nvPr/>
        </p:nvSpPr>
        <p:spPr>
          <a:xfrm flipH="1">
            <a:off x="3901335" y="3599020"/>
            <a:ext cx="277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072124B9-4E49-BE75-9C37-EA3F08EBB33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5414" t="83062" r="23287" b="3326"/>
          <a:stretch>
            <a:fillRect/>
          </a:stretch>
        </p:blipFill>
        <p:spPr>
          <a:xfrm>
            <a:off x="5615979" y="3779796"/>
            <a:ext cx="414036" cy="637277"/>
          </a:xfrm>
          <a:prstGeom prst="rect">
            <a:avLst/>
          </a:prstGeom>
        </p:spPr>
      </p:pic>
      <p:grpSp>
        <p:nvGrpSpPr>
          <p:cNvPr id="145" name="Group 144">
            <a:extLst>
              <a:ext uri="{FF2B5EF4-FFF2-40B4-BE49-F238E27FC236}">
                <a16:creationId xmlns:a16="http://schemas.microsoft.com/office/drawing/2014/main" id="{2F6CBB8F-B55C-D592-68AC-F6D946148876}"/>
              </a:ext>
            </a:extLst>
          </p:cNvPr>
          <p:cNvGrpSpPr/>
          <p:nvPr/>
        </p:nvGrpSpPr>
        <p:grpSpPr>
          <a:xfrm>
            <a:off x="3811754" y="5826201"/>
            <a:ext cx="2297897" cy="2970594"/>
            <a:chOff x="3801122" y="5592285"/>
            <a:chExt cx="2297897" cy="2970594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6329583F-0C14-DA04-DD55-EC3DFE44B38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3842" t="15839" r="15692" b="33450"/>
            <a:stretch>
              <a:fillRect/>
            </a:stretch>
          </p:blipFill>
          <p:spPr>
            <a:xfrm>
              <a:off x="4509835" y="6572116"/>
              <a:ext cx="1093899" cy="1126516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7B6762F5-1CFD-27F7-77F5-64B5AAC6CC88}"/>
                </a:ext>
              </a:extLst>
            </p:cNvPr>
            <p:cNvSpPr txBox="1"/>
            <p:nvPr/>
          </p:nvSpPr>
          <p:spPr>
            <a:xfrm rot="16200000">
              <a:off x="3684505" y="7027640"/>
              <a:ext cx="118115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% development stage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290C1960-84A0-DEF9-1642-25255B012458}"/>
                </a:ext>
              </a:extLst>
            </p:cNvPr>
            <p:cNvSpPr txBox="1"/>
            <p:nvPr/>
          </p:nvSpPr>
          <p:spPr>
            <a:xfrm rot="16200000">
              <a:off x="4452836" y="7829854"/>
              <a:ext cx="583739" cy="2000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ctrl(RNAi)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B031789F-3491-EA21-504D-DEE5CD38ACBC}"/>
                </a:ext>
              </a:extLst>
            </p:cNvPr>
            <p:cNvSpPr txBox="1"/>
            <p:nvPr/>
          </p:nvSpPr>
          <p:spPr>
            <a:xfrm rot="16200000">
              <a:off x="4670208" y="7829855"/>
              <a:ext cx="7763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yap-1(RNAi)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D0523B31-9AB7-46D8-63DB-3BB30BD503D6}"/>
                </a:ext>
              </a:extLst>
            </p:cNvPr>
            <p:cNvSpPr txBox="1"/>
            <p:nvPr/>
          </p:nvSpPr>
          <p:spPr>
            <a:xfrm rot="16200000">
              <a:off x="4965400" y="7829855"/>
              <a:ext cx="8083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egl-44(RNAi)</a:t>
              </a:r>
              <a:endParaRPr lang="en-US" sz="5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3022968D-485B-F97A-95F1-CFBFCBEB1AE3}"/>
                </a:ext>
              </a:extLst>
            </p:cNvPr>
            <p:cNvSpPr txBox="1"/>
            <p:nvPr/>
          </p:nvSpPr>
          <p:spPr>
            <a:xfrm>
              <a:off x="4274017" y="6512630"/>
              <a:ext cx="315035" cy="181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09C3A61-7720-1957-52E9-18C121F09F69}"/>
                </a:ext>
              </a:extLst>
            </p:cNvPr>
            <p:cNvSpPr txBox="1"/>
            <p:nvPr/>
          </p:nvSpPr>
          <p:spPr>
            <a:xfrm>
              <a:off x="4270896" y="6717533"/>
              <a:ext cx="315035" cy="181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 80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65327238-0B39-E096-AA91-7F583AC80D97}"/>
                </a:ext>
              </a:extLst>
            </p:cNvPr>
            <p:cNvSpPr txBox="1"/>
            <p:nvPr/>
          </p:nvSpPr>
          <p:spPr>
            <a:xfrm>
              <a:off x="4269787" y="6932878"/>
              <a:ext cx="315035" cy="181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 6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8C1D0CC2-212F-9C07-9B0E-E21930BEDE4E}"/>
                </a:ext>
              </a:extLst>
            </p:cNvPr>
            <p:cNvSpPr txBox="1"/>
            <p:nvPr/>
          </p:nvSpPr>
          <p:spPr>
            <a:xfrm>
              <a:off x="4270763" y="7152597"/>
              <a:ext cx="315035" cy="181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 40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E243027A-BD1F-78FF-1F1C-BB3E5541B001}"/>
                </a:ext>
              </a:extLst>
            </p:cNvPr>
            <p:cNvSpPr txBox="1"/>
            <p:nvPr/>
          </p:nvSpPr>
          <p:spPr>
            <a:xfrm>
              <a:off x="4274487" y="7370319"/>
              <a:ext cx="315035" cy="181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 20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9584BC4A-ACF8-4AEA-D086-5D62B00DAC6F}"/>
                </a:ext>
              </a:extLst>
            </p:cNvPr>
            <p:cNvSpPr txBox="1"/>
            <p:nvPr/>
          </p:nvSpPr>
          <p:spPr>
            <a:xfrm>
              <a:off x="4313023" y="7575178"/>
              <a:ext cx="315035" cy="181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 0</a:t>
              </a:r>
            </a:p>
          </p:txBody>
        </p: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71A93CB5-1709-4BF0-9121-E6AA4473E20D}"/>
                </a:ext>
              </a:extLst>
            </p:cNvPr>
            <p:cNvCxnSpPr>
              <a:cxnSpLocks/>
            </p:cNvCxnSpPr>
            <p:nvPr/>
          </p:nvCxnSpPr>
          <p:spPr>
            <a:xfrm>
              <a:off x="4569085" y="8373234"/>
              <a:ext cx="93441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F9B9CDA4-3E87-A0C5-730E-04C418D8D5E5}"/>
                </a:ext>
              </a:extLst>
            </p:cNvPr>
            <p:cNvSpPr txBox="1"/>
            <p:nvPr/>
          </p:nvSpPr>
          <p:spPr>
            <a:xfrm>
              <a:off x="4760238" y="8366160"/>
              <a:ext cx="486717" cy="196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 Auxin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0CE5E799-9ED6-9CF4-74CB-86F56E89D540}"/>
                </a:ext>
              </a:extLst>
            </p:cNvPr>
            <p:cNvSpPr txBox="1"/>
            <p:nvPr/>
          </p:nvSpPr>
          <p:spPr>
            <a:xfrm>
              <a:off x="4897407" y="6470634"/>
              <a:ext cx="334469" cy="196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F6ECE214-3848-5A6B-C0FC-C97538C129F4}"/>
                </a:ext>
              </a:extLst>
            </p:cNvPr>
            <p:cNvSpPr txBox="1"/>
            <p:nvPr/>
          </p:nvSpPr>
          <p:spPr>
            <a:xfrm>
              <a:off x="5215943" y="6470634"/>
              <a:ext cx="334469" cy="196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A9C9A074-EF68-7C25-6098-342BF6CBE9D3}"/>
                </a:ext>
              </a:extLst>
            </p:cNvPr>
            <p:cNvSpPr txBox="1"/>
            <p:nvPr/>
          </p:nvSpPr>
          <p:spPr>
            <a:xfrm>
              <a:off x="4567490" y="7498578"/>
              <a:ext cx="3422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59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ED9753E8-E7A3-19CC-B70C-DDFA00D4187F}"/>
                </a:ext>
              </a:extLst>
            </p:cNvPr>
            <p:cNvSpPr txBox="1"/>
            <p:nvPr/>
          </p:nvSpPr>
          <p:spPr>
            <a:xfrm>
              <a:off x="4894634" y="7498578"/>
              <a:ext cx="3422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13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254F43C9-4636-6829-1D63-B282104FF780}"/>
                </a:ext>
              </a:extLst>
            </p:cNvPr>
            <p:cNvSpPr txBox="1"/>
            <p:nvPr/>
          </p:nvSpPr>
          <p:spPr>
            <a:xfrm>
              <a:off x="5208856" y="7498578"/>
              <a:ext cx="3422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94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D13FC778-A7C9-CAB4-7A4D-42735F0E82D3}"/>
                </a:ext>
              </a:extLst>
            </p:cNvPr>
            <p:cNvSpPr txBox="1"/>
            <p:nvPr/>
          </p:nvSpPr>
          <p:spPr>
            <a:xfrm>
              <a:off x="4121704" y="5592285"/>
              <a:ext cx="6502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uxin + 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ctrl(RNAi) 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D0A57B71-DC0C-832A-807A-ED7698329D99}"/>
                </a:ext>
              </a:extLst>
            </p:cNvPr>
            <p:cNvSpPr txBox="1"/>
            <p:nvPr/>
          </p:nvSpPr>
          <p:spPr>
            <a:xfrm>
              <a:off x="4771768" y="5592285"/>
              <a:ext cx="6838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uxin + </a:t>
              </a:r>
            </a:p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yap-1(RNAi)  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327E95C4-3D1D-AF93-7CEF-D4CF624CE843}"/>
                </a:ext>
              </a:extLst>
            </p:cNvPr>
            <p:cNvSpPr txBox="1"/>
            <p:nvPr/>
          </p:nvSpPr>
          <p:spPr>
            <a:xfrm>
              <a:off x="5402639" y="5592285"/>
              <a:ext cx="6963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 Auxin + 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egl-44(RNAi)</a:t>
              </a:r>
              <a:endParaRPr lang="en-US" sz="5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2" name="Picture 91" descr="A close-up of several worms&#10;&#10;Description automatically generated">
              <a:extLst>
                <a:ext uri="{FF2B5EF4-FFF2-40B4-BE49-F238E27FC236}">
                  <a16:creationId xmlns:a16="http://schemas.microsoft.com/office/drawing/2014/main" id="{FF32CF3A-F88F-EC38-4ECE-787708EB5E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93337" y="5871994"/>
              <a:ext cx="650239" cy="548640"/>
            </a:xfrm>
            <a:prstGeom prst="rect">
              <a:avLst/>
            </a:prstGeom>
          </p:spPr>
        </p:pic>
        <p:pic>
          <p:nvPicPr>
            <p:cNvPr id="93" name="Picture 92" descr="A group of worms on a surface&#10;&#10;Description automatically generated">
              <a:extLst>
                <a:ext uri="{FF2B5EF4-FFF2-40B4-BE49-F238E27FC236}">
                  <a16:creationId xmlns:a16="http://schemas.microsoft.com/office/drawing/2014/main" id="{D1DBE786-6751-7010-3727-5A5ABA9F980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771057" y="5868473"/>
              <a:ext cx="650241" cy="548640"/>
            </a:xfrm>
            <a:prstGeom prst="rect">
              <a:avLst/>
            </a:prstGeom>
          </p:spPr>
        </p:pic>
        <p:pic>
          <p:nvPicPr>
            <p:cNvPr id="94" name="Picture 93" descr="A close-up of several worms&#10;&#10;Description automatically generated">
              <a:extLst>
                <a:ext uri="{FF2B5EF4-FFF2-40B4-BE49-F238E27FC236}">
                  <a16:creationId xmlns:a16="http://schemas.microsoft.com/office/drawing/2014/main" id="{F6519C8D-511F-789B-92E5-E8B425661A1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48779" y="5868852"/>
              <a:ext cx="650240" cy="548640"/>
            </a:xfrm>
            <a:prstGeom prst="rect">
              <a:avLst/>
            </a:prstGeom>
          </p:spPr>
        </p:pic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A03548DF-B199-297C-4B2D-D2564F39FD23}"/>
                </a:ext>
              </a:extLst>
            </p:cNvPr>
            <p:cNvSpPr txBox="1"/>
            <p:nvPr/>
          </p:nvSpPr>
          <p:spPr>
            <a:xfrm rot="16200000">
              <a:off x="3554058" y="5979789"/>
              <a:ext cx="8019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ID*::WTS-1 + somatic TIR1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E143631C-FFAA-2111-9106-196E2DB9E679}"/>
                </a:ext>
              </a:extLst>
            </p:cNvPr>
            <p:cNvSpPr txBox="1"/>
            <p:nvPr/>
          </p:nvSpPr>
          <p:spPr>
            <a:xfrm>
              <a:off x="4027335" y="5818445"/>
              <a:ext cx="2757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54E17B4B-4FD9-3AF0-5952-CE86FC9780AB}"/>
                </a:ext>
              </a:extLst>
            </p:cNvPr>
            <p:cNvSpPr txBox="1"/>
            <p:nvPr/>
          </p:nvSpPr>
          <p:spPr>
            <a:xfrm>
              <a:off x="4696872" y="5818445"/>
              <a:ext cx="2757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2A111960-B827-10AC-4E76-A57373B7A329}"/>
                </a:ext>
              </a:extLst>
            </p:cNvPr>
            <p:cNvSpPr txBox="1"/>
            <p:nvPr/>
          </p:nvSpPr>
          <p:spPr>
            <a:xfrm>
              <a:off x="5384185" y="5818445"/>
              <a:ext cx="2757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2F0648F6-DBFA-BAE0-6EB4-616F50BFB925}"/>
                </a:ext>
              </a:extLst>
            </p:cNvPr>
            <p:cNvSpPr txBox="1"/>
            <p:nvPr/>
          </p:nvSpPr>
          <p:spPr>
            <a:xfrm>
              <a:off x="4031852" y="6416844"/>
              <a:ext cx="2757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71A58418-4D28-05D8-075E-E8A9FCD66DB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5414" t="83062" r="23287" b="3326"/>
            <a:stretch>
              <a:fillRect/>
            </a:stretch>
          </p:blipFill>
          <p:spPr>
            <a:xfrm>
              <a:off x="5539397" y="6534630"/>
              <a:ext cx="414036" cy="637277"/>
            </a:xfrm>
            <a:prstGeom prst="rect">
              <a:avLst/>
            </a:prstGeom>
          </p:spPr>
        </p:pic>
      </p:grpSp>
      <p:pic>
        <p:nvPicPr>
          <p:cNvPr id="35" name="Picture 34">
            <a:extLst>
              <a:ext uri="{FF2B5EF4-FFF2-40B4-BE49-F238E27FC236}">
                <a16:creationId xmlns:a16="http://schemas.microsoft.com/office/drawing/2014/main" id="{0920A6F6-1F3D-8666-4C62-E51CCD8185B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5414" t="83062" r="23287" b="3326"/>
          <a:stretch>
            <a:fillRect/>
          </a:stretch>
        </p:blipFill>
        <p:spPr>
          <a:xfrm>
            <a:off x="1943675" y="6861301"/>
            <a:ext cx="414036" cy="637277"/>
          </a:xfrm>
          <a:prstGeom prst="rect">
            <a:avLst/>
          </a:prstGeom>
        </p:spPr>
      </p:pic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73850491-4DAC-F6DB-086D-37C9102EC668}"/>
              </a:ext>
            </a:extLst>
          </p:cNvPr>
          <p:cNvCxnSpPr/>
          <p:nvPr/>
        </p:nvCxnSpPr>
        <p:spPr>
          <a:xfrm>
            <a:off x="4584963" y="2676659"/>
            <a:ext cx="0" cy="1397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Oval 32">
            <a:extLst>
              <a:ext uri="{FF2B5EF4-FFF2-40B4-BE49-F238E27FC236}">
                <a16:creationId xmlns:a16="http://schemas.microsoft.com/office/drawing/2014/main" id="{D868ADD8-FC35-9905-CB31-257E1A1A1D84}"/>
              </a:ext>
            </a:extLst>
          </p:cNvPr>
          <p:cNvSpPr/>
          <p:nvPr/>
        </p:nvSpPr>
        <p:spPr>
          <a:xfrm>
            <a:off x="4523678" y="2655418"/>
            <a:ext cx="120672" cy="126999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EBCF4E3-7AF5-8086-468E-5E14BA469E3C}"/>
              </a:ext>
            </a:extLst>
          </p:cNvPr>
          <p:cNvSpPr txBox="1"/>
          <p:nvPr/>
        </p:nvSpPr>
        <p:spPr>
          <a:xfrm>
            <a:off x="4468401" y="2630795"/>
            <a:ext cx="2985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81D6F041-F40C-6A5F-92AB-6D454D4DFB5F}"/>
              </a:ext>
            </a:extLst>
          </p:cNvPr>
          <p:cNvGrpSpPr/>
          <p:nvPr/>
        </p:nvGrpSpPr>
        <p:grpSpPr>
          <a:xfrm>
            <a:off x="1299964" y="2809368"/>
            <a:ext cx="4294339" cy="303046"/>
            <a:chOff x="3104548" y="3708013"/>
            <a:chExt cx="2091726" cy="181751"/>
          </a:xfrm>
        </p:grpSpPr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D4F6C788-D4FE-1CF0-7FAF-896931C4AA58}"/>
                </a:ext>
              </a:extLst>
            </p:cNvPr>
            <p:cNvSpPr/>
            <p:nvPr/>
          </p:nvSpPr>
          <p:spPr>
            <a:xfrm>
              <a:off x="3104548" y="3708019"/>
              <a:ext cx="83632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6FBF9AE6-9B7E-B473-F8E8-A1FEA5042E4B}"/>
                </a:ext>
              </a:extLst>
            </p:cNvPr>
            <p:cNvSpPr/>
            <p:nvPr/>
          </p:nvSpPr>
          <p:spPr>
            <a:xfrm>
              <a:off x="3190262" y="3708019"/>
              <a:ext cx="206988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3" name="Rectangle 132">
              <a:extLst>
                <a:ext uri="{FF2B5EF4-FFF2-40B4-BE49-F238E27FC236}">
                  <a16:creationId xmlns:a16="http://schemas.microsoft.com/office/drawing/2014/main" id="{059AE31F-E45B-E004-D8E6-8BAB17EA0030}"/>
                </a:ext>
              </a:extLst>
            </p:cNvPr>
            <p:cNvSpPr/>
            <p:nvPr/>
          </p:nvSpPr>
          <p:spPr>
            <a:xfrm>
              <a:off x="3394707" y="3708018"/>
              <a:ext cx="206988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26EDBEEF-65B4-4583-41F5-330C44D23F4A}"/>
                </a:ext>
              </a:extLst>
            </p:cNvPr>
            <p:cNvSpPr/>
            <p:nvPr/>
          </p:nvSpPr>
          <p:spPr>
            <a:xfrm>
              <a:off x="3598556" y="3708018"/>
              <a:ext cx="154294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6242DF63-1ED2-401D-BD9B-718CE7572881}"/>
                </a:ext>
              </a:extLst>
            </p:cNvPr>
            <p:cNvSpPr/>
            <p:nvPr/>
          </p:nvSpPr>
          <p:spPr>
            <a:xfrm>
              <a:off x="3753864" y="3708017"/>
              <a:ext cx="83632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FA32CF7B-5D87-CA25-D7BC-08F61E2438A7}"/>
                </a:ext>
              </a:extLst>
            </p:cNvPr>
            <p:cNvSpPr/>
            <p:nvPr/>
          </p:nvSpPr>
          <p:spPr>
            <a:xfrm>
              <a:off x="3835758" y="3708016"/>
              <a:ext cx="83632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7667BFF0-7C90-58D7-6867-4C533CF4B6E3}"/>
                </a:ext>
              </a:extLst>
            </p:cNvPr>
            <p:cNvSpPr/>
            <p:nvPr/>
          </p:nvSpPr>
          <p:spPr>
            <a:xfrm>
              <a:off x="3919363" y="3708015"/>
              <a:ext cx="437946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50AA789C-C687-A91E-08DE-8E1A7566C69B}"/>
                </a:ext>
              </a:extLst>
            </p:cNvPr>
            <p:cNvSpPr/>
            <p:nvPr/>
          </p:nvSpPr>
          <p:spPr>
            <a:xfrm>
              <a:off x="4355649" y="3708015"/>
              <a:ext cx="240732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97C38247-FC72-8675-2B3D-BB3074DEB359}"/>
                </a:ext>
              </a:extLst>
            </p:cNvPr>
            <p:cNvSpPr/>
            <p:nvPr/>
          </p:nvSpPr>
          <p:spPr>
            <a:xfrm>
              <a:off x="4597719" y="3708014"/>
              <a:ext cx="284485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B1207958-2480-C1CD-7FA2-BBFA654554ED}"/>
                </a:ext>
              </a:extLst>
            </p:cNvPr>
            <p:cNvSpPr/>
            <p:nvPr/>
          </p:nvSpPr>
          <p:spPr>
            <a:xfrm>
              <a:off x="4884949" y="3708013"/>
              <a:ext cx="154295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420E53B2-1182-64DB-AC80-9C8818B2A7D5}"/>
                </a:ext>
              </a:extLst>
            </p:cNvPr>
            <p:cNvSpPr/>
            <p:nvPr/>
          </p:nvSpPr>
          <p:spPr>
            <a:xfrm>
              <a:off x="5041979" y="3708013"/>
              <a:ext cx="154295" cy="1817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75" name="TextBox 74">
            <a:extLst>
              <a:ext uri="{FF2B5EF4-FFF2-40B4-BE49-F238E27FC236}">
                <a16:creationId xmlns:a16="http://schemas.microsoft.com/office/drawing/2014/main" id="{BBE2513F-A95E-FE31-0C56-A1381E636FA7}"/>
              </a:ext>
            </a:extLst>
          </p:cNvPr>
          <p:cNvSpPr txBox="1"/>
          <p:nvPr/>
        </p:nvSpPr>
        <p:spPr>
          <a:xfrm>
            <a:off x="2174668" y="2486203"/>
            <a:ext cx="4754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PxY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94C5734-6F8F-4793-66BC-7DD72A395F68}"/>
              </a:ext>
            </a:extLst>
          </p:cNvPr>
          <p:cNvSpPr txBox="1"/>
          <p:nvPr/>
        </p:nvSpPr>
        <p:spPr>
          <a:xfrm>
            <a:off x="2946933" y="2486202"/>
            <a:ext cx="4754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PxY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E5B9AAE8-B98C-4105-D035-A89ED6904FCB}"/>
              </a:ext>
            </a:extLst>
          </p:cNvPr>
          <p:cNvSpPr txBox="1"/>
          <p:nvPr/>
        </p:nvSpPr>
        <p:spPr>
          <a:xfrm rot="18992836">
            <a:off x="4950263" y="2467172"/>
            <a:ext cx="6788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_TK_X 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73A1D999-78B5-879B-2541-AA68A83C8E81}"/>
              </a:ext>
            </a:extLst>
          </p:cNvPr>
          <p:cNvSpPr txBox="1"/>
          <p:nvPr/>
        </p:nvSpPr>
        <p:spPr>
          <a:xfrm rot="19242020">
            <a:off x="3856090" y="2328124"/>
            <a:ext cx="11416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/T kinase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CDB40CED-2063-BF08-E516-9E3AFA7F1ECA}"/>
              </a:ext>
            </a:extLst>
          </p:cNvPr>
          <p:cNvSpPr txBox="1"/>
          <p:nvPr/>
        </p:nvSpPr>
        <p:spPr>
          <a:xfrm rot="19227225">
            <a:off x="3311744" y="2332324"/>
            <a:ext cx="11416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OB-binding region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6E816637-477F-E306-1EA9-EF7CF7CE0E89}"/>
              </a:ext>
            </a:extLst>
          </p:cNvPr>
          <p:cNvSpPr txBox="1"/>
          <p:nvPr/>
        </p:nvSpPr>
        <p:spPr>
          <a:xfrm>
            <a:off x="1055044" y="3182384"/>
            <a:ext cx="10320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436 </a:t>
            </a:r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endParaRPr lang="en-US" sz="800" b="1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BB156792-3A83-EAAD-B7C8-D0CF81214A9A}"/>
              </a:ext>
            </a:extLst>
          </p:cNvPr>
          <p:cNvSpPr/>
          <p:nvPr/>
        </p:nvSpPr>
        <p:spPr>
          <a:xfrm>
            <a:off x="802207" y="2456772"/>
            <a:ext cx="1087895" cy="178833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T2::2xMyc::AID*</a:t>
            </a: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55E06358-9CF7-1E9C-6543-F6FBAAE2DB36}"/>
              </a:ext>
            </a:extLst>
          </p:cNvPr>
          <p:cNvCxnSpPr>
            <a:cxnSpLocks/>
          </p:cNvCxnSpPr>
          <p:nvPr/>
        </p:nvCxnSpPr>
        <p:spPr>
          <a:xfrm flipV="1">
            <a:off x="1321488" y="2642664"/>
            <a:ext cx="566752" cy="1179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89AE8B45-C314-55A3-63D7-1680123EE053}"/>
              </a:ext>
            </a:extLst>
          </p:cNvPr>
          <p:cNvCxnSpPr>
            <a:cxnSpLocks/>
          </p:cNvCxnSpPr>
          <p:nvPr/>
        </p:nvCxnSpPr>
        <p:spPr>
          <a:xfrm>
            <a:off x="806661" y="2637143"/>
            <a:ext cx="519733" cy="1214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C0EC385C-3167-2F29-C4AD-197EE834642E}"/>
              </a:ext>
            </a:extLst>
          </p:cNvPr>
          <p:cNvCxnSpPr>
            <a:cxnSpLocks/>
          </p:cNvCxnSpPr>
          <p:nvPr/>
        </p:nvCxnSpPr>
        <p:spPr>
          <a:xfrm flipV="1">
            <a:off x="1323681" y="2754182"/>
            <a:ext cx="0" cy="489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1924E07A-2490-2FFC-5C0B-071A40EF1D4A}"/>
              </a:ext>
            </a:extLst>
          </p:cNvPr>
          <p:cNvSpPr txBox="1"/>
          <p:nvPr/>
        </p:nvSpPr>
        <p:spPr>
          <a:xfrm>
            <a:off x="2996071" y="3182384"/>
            <a:ext cx="9297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△1</a:t>
            </a:r>
            <a:r>
              <a:rPr lang="en-US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m4081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BB5FC3B9-D8FF-531A-69BF-BA6C2F0C5C57}"/>
              </a:ext>
            </a:extLst>
          </p:cNvPr>
          <p:cNvSpPr txBox="1"/>
          <p:nvPr/>
        </p:nvSpPr>
        <p:spPr>
          <a:xfrm>
            <a:off x="3824427" y="3182384"/>
            <a:ext cx="8813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△2</a:t>
            </a:r>
            <a:r>
              <a:rPr lang="en-US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k753</a:t>
            </a: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BD35B241-E92A-1C76-4DA0-B7BD46F5CE4D}"/>
              </a:ext>
            </a:extLst>
          </p:cNvPr>
          <p:cNvCxnSpPr>
            <a:cxnSpLocks/>
          </p:cNvCxnSpPr>
          <p:nvPr/>
        </p:nvCxnSpPr>
        <p:spPr>
          <a:xfrm>
            <a:off x="2981081" y="3211435"/>
            <a:ext cx="73152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24" name="Oval 123">
            <a:extLst>
              <a:ext uri="{FF2B5EF4-FFF2-40B4-BE49-F238E27FC236}">
                <a16:creationId xmlns:a16="http://schemas.microsoft.com/office/drawing/2014/main" id="{51FBA43C-2F19-509A-602D-48065CD5CA3B}"/>
              </a:ext>
            </a:extLst>
          </p:cNvPr>
          <p:cNvSpPr/>
          <p:nvPr/>
        </p:nvSpPr>
        <p:spPr>
          <a:xfrm>
            <a:off x="5288780" y="2655417"/>
            <a:ext cx="120672" cy="126999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2EDC0042-D498-0E26-C438-21212043E250}"/>
              </a:ext>
            </a:extLst>
          </p:cNvPr>
          <p:cNvCxnSpPr/>
          <p:nvPr/>
        </p:nvCxnSpPr>
        <p:spPr>
          <a:xfrm>
            <a:off x="5347758" y="2669667"/>
            <a:ext cx="0" cy="1397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99ED0ED2-80D4-4C06-1CCD-FD590845DC14}"/>
              </a:ext>
            </a:extLst>
          </p:cNvPr>
          <p:cNvSpPr txBox="1"/>
          <p:nvPr/>
        </p:nvSpPr>
        <p:spPr>
          <a:xfrm>
            <a:off x="5236907" y="2631693"/>
            <a:ext cx="2985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27" name="Triangle 126">
            <a:extLst>
              <a:ext uri="{FF2B5EF4-FFF2-40B4-BE49-F238E27FC236}">
                <a16:creationId xmlns:a16="http://schemas.microsoft.com/office/drawing/2014/main" id="{6E68396B-7A9C-1047-440D-6707CF22F381}"/>
              </a:ext>
            </a:extLst>
          </p:cNvPr>
          <p:cNvSpPr/>
          <p:nvPr/>
        </p:nvSpPr>
        <p:spPr>
          <a:xfrm>
            <a:off x="1270783" y="3116341"/>
            <a:ext cx="110220" cy="9509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312F2C7D-FE5A-E116-95B0-BF0AAE922CC9}"/>
              </a:ext>
            </a:extLst>
          </p:cNvPr>
          <p:cNvSpPr txBox="1"/>
          <p:nvPr/>
        </p:nvSpPr>
        <p:spPr>
          <a:xfrm flipH="1">
            <a:off x="207859" y="2182457"/>
            <a:ext cx="4300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0BB57799-FF31-FD13-534F-916F57E3B9E8}"/>
              </a:ext>
            </a:extLst>
          </p:cNvPr>
          <p:cNvCxnSpPr>
            <a:cxnSpLocks/>
          </p:cNvCxnSpPr>
          <p:nvPr/>
        </p:nvCxnSpPr>
        <p:spPr>
          <a:xfrm>
            <a:off x="3925797" y="3211435"/>
            <a:ext cx="36576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93C9660B-F48B-535A-977B-B35F06F672FE}"/>
              </a:ext>
            </a:extLst>
          </p:cNvPr>
          <p:cNvCxnSpPr>
            <a:cxnSpLocks/>
          </p:cNvCxnSpPr>
          <p:nvPr/>
        </p:nvCxnSpPr>
        <p:spPr>
          <a:xfrm>
            <a:off x="2841914" y="3211435"/>
            <a:ext cx="168212" cy="0"/>
          </a:xfrm>
          <a:prstGeom prst="line">
            <a:avLst/>
          </a:prstGeom>
          <a:ln w="25400">
            <a:solidFill>
              <a:srgbClr val="FF0000"/>
            </a:solidFill>
            <a:prstDash val="sysDot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2457E382-36B0-927A-2FBF-B9D57440926F}"/>
              </a:ext>
            </a:extLst>
          </p:cNvPr>
          <p:cNvCxnSpPr>
            <a:cxnSpLocks/>
          </p:cNvCxnSpPr>
          <p:nvPr/>
        </p:nvCxnSpPr>
        <p:spPr>
          <a:xfrm>
            <a:off x="4590960" y="1278416"/>
            <a:ext cx="219337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71" name="TextBox 170">
            <a:extLst>
              <a:ext uri="{FF2B5EF4-FFF2-40B4-BE49-F238E27FC236}">
                <a16:creationId xmlns:a16="http://schemas.microsoft.com/office/drawing/2014/main" id="{9F558BC2-39E7-584D-B338-6F9C9336B27F}"/>
              </a:ext>
            </a:extLst>
          </p:cNvPr>
          <p:cNvSpPr txBox="1"/>
          <p:nvPr/>
        </p:nvSpPr>
        <p:spPr>
          <a:xfrm>
            <a:off x="473363" y="2806335"/>
            <a:ext cx="7475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S-1</a:t>
            </a:r>
          </a:p>
        </p:txBody>
      </p:sp>
    </p:spTree>
    <p:extLst>
      <p:ext uri="{BB962C8B-B14F-4D97-AF65-F5344CB8AC3E}">
        <p14:creationId xmlns:p14="http://schemas.microsoft.com/office/powerpoint/2010/main" val="1044831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8D64F20-5B7B-9349-929D-2288BDB2546B}"/>
              </a:ext>
            </a:extLst>
          </p:cNvPr>
          <p:cNvSpPr txBox="1"/>
          <p:nvPr/>
        </p:nvSpPr>
        <p:spPr>
          <a:xfrm>
            <a:off x="177799" y="135467"/>
            <a:ext cx="6468533" cy="8448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</a:pPr>
            <a:endParaRPr lang="en-US" sz="800" kern="100" dirty="0">
              <a:latin typeface="Courier New" panose="02070309020205020404" pitchFamily="49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800" kern="100" dirty="0">
                <a:latin typeface="Courier New" panose="02070309020205020404" pitchFamily="49" charset="0"/>
                <a:ea typeface="Aptos"/>
              </a:rPr>
              <a:t> 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Aptos"/>
              </a:rPr>
              <a:t>UBA domain</a:t>
            </a:r>
            <a:r>
              <a:rPr lang="en-US" sz="1000" kern="100" dirty="0">
                <a:solidFill>
                  <a:srgbClr val="000000"/>
                </a:solidFill>
                <a:latin typeface="Courier New" panose="02070309020205020404" pitchFamily="49" charset="0"/>
                <a:ea typeface="Aptos"/>
              </a:rPr>
              <a:t>: involved in ubiquitin/proteasome pathway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highlight>
                  <a:srgbClr val="D3D3D3"/>
                </a:highlight>
                <a:latin typeface="Courier New" panose="02070309020205020404" pitchFamily="49" charset="0"/>
                <a:ea typeface="Aptos"/>
              </a:rPr>
              <a:t>Gray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Poly-Pro region defined by consecutive Prolines.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Blue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S/T kinase domain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Dk blue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S_TK_X domain: kinase extension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Yellow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NTR/MOB-binding region. N-terminal regulatory region, a 70-80 residue segment immediately N-terminal to the catalytic kinase domain, that binds MOB co-activator of NDR/LATS kinases (Parker et al., 2022). 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Underlines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</a:t>
            </a:r>
            <a:r>
              <a:rPr lang="en-US" sz="1000" kern="100" dirty="0">
                <a:latin typeface="Cambria Math" panose="02040503050406030204" pitchFamily="18" charset="0"/>
                <a:ea typeface="Aptos"/>
                <a:cs typeface="Cambria Math" panose="02040503050406030204" pitchFamily="18" charset="0"/>
              </a:rPr>
              <a:t>⍺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MOBA and </a:t>
            </a:r>
            <a:r>
              <a:rPr lang="en-US" sz="1000" kern="100" dirty="0">
                <a:latin typeface="Cambria Math" panose="02040503050406030204" pitchFamily="18" charset="0"/>
                <a:ea typeface="Aptos"/>
                <a:cs typeface="Cambria Math" panose="02040503050406030204" pitchFamily="18" charset="0"/>
              </a:rPr>
              <a:t>⍺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MOBB: alpha helices in Warts/LATS that interact with MOB.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Conserved binding interfaces in NTR/MOB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</a:t>
            </a:r>
            <a:r>
              <a:rPr lang="en-US" sz="1000" b="1" kern="100" dirty="0">
                <a:latin typeface="Courier New" panose="02070309020205020404" pitchFamily="49" charset="0"/>
                <a:ea typeface="Aptos"/>
              </a:rPr>
              <a:t>bold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residues. </a:t>
            </a:r>
            <a:r>
              <a:rPr lang="en-US" sz="1000" b="1" kern="100" dirty="0">
                <a:solidFill>
                  <a:srgbClr val="FFC000"/>
                </a:solidFill>
                <a:latin typeface="Courier New" panose="02070309020205020404" pitchFamily="49" charset="0"/>
                <a:ea typeface="Aptos"/>
              </a:rPr>
              <a:t>Orange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hydrophobic, </a:t>
            </a:r>
            <a:r>
              <a:rPr lang="en-US" sz="1000" b="1" kern="100" dirty="0">
                <a:solidFill>
                  <a:srgbClr val="0070C0"/>
                </a:solidFill>
                <a:latin typeface="Courier New" panose="02070309020205020404" pitchFamily="49" charset="0"/>
                <a:ea typeface="Aptos"/>
              </a:rPr>
              <a:t>Blue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basic (</a:t>
            </a:r>
            <a:r>
              <a:rPr lang="en-US" sz="1000" b="1" kern="100" dirty="0">
                <a:solidFill>
                  <a:srgbClr val="00B0F0"/>
                </a:solidFill>
                <a:latin typeface="Courier New" panose="02070309020205020404" pitchFamily="49" charset="0"/>
                <a:ea typeface="Aptos"/>
              </a:rPr>
              <a:t>lt blue 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= basic, conservative), </a:t>
            </a:r>
            <a:r>
              <a:rPr lang="en-US" sz="1000" b="1" kern="100" dirty="0">
                <a:solidFill>
                  <a:srgbClr val="C00000"/>
                </a:solidFill>
                <a:latin typeface="Courier New" panose="02070309020205020404" pitchFamily="49" charset="0"/>
                <a:ea typeface="Aptos"/>
              </a:rPr>
              <a:t>Red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acidic, </a:t>
            </a:r>
            <a:r>
              <a:rPr lang="en-US" sz="1000" b="1" kern="100" dirty="0">
                <a:solidFill>
                  <a:srgbClr val="000000"/>
                </a:solidFill>
                <a:latin typeface="Courier New" panose="02070309020205020404" pitchFamily="49" charset="0"/>
                <a:ea typeface="Aptos"/>
              </a:rPr>
              <a:t>Black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identical, </a:t>
            </a:r>
            <a:r>
              <a:rPr lang="en-US" sz="1000" b="1" kern="100" dirty="0">
                <a:solidFill>
                  <a:srgbClr val="808080"/>
                </a:solidFill>
                <a:latin typeface="Courier New" panose="02070309020205020404" pitchFamily="49" charset="0"/>
                <a:ea typeface="Aptos"/>
              </a:rPr>
              <a:t>Gray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conservative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x</a:t>
            </a:r>
            <a:r>
              <a:rPr lang="en-US" sz="10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Pro-Pro-any-Tyr motif that is recognized by WW domains in Yki/YAP/TAZ (Verma et al. 2018)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highlight>
                  <a:srgbClr val="D3D3D3"/>
                </a:highlight>
                <a:latin typeface="Courier New" panose="02070309020205020404" pitchFamily="49" charset="0"/>
                <a:ea typeface="Aptos"/>
              </a:rPr>
              <a:t>Gray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Poly-Pro region defined by consecutive Prolines.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YE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RR: at the end of the S_TK_X domain is the hydrophobic motif(HM) and phosphorylation consensus site for Hippo/MST and CNH-domain MAP4 kinases. This is T1079 for LATS1 and T1041 for LATS2.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Activation loop autophosphosite (S909 in LATS1)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endParaRPr lang="en-US" sz="1000" dirty="0"/>
          </a:p>
          <a:p>
            <a:endParaRPr lang="en-US" sz="1000" dirty="0"/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LUSTAL O(1.2.4) multiple sequence alignment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------------------------------------------------------------	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------------MH-----------------------------------PAGEK------	7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MKRSEKPEGYRQMRPKTFPASNYTVSSRQMLQEIRESLRNLSKPSDAAKA----------	5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------------MRPKTFPATTYSGNSRQRLQEIREGLKQPSKSSVQGLPAGPNSDTSLD	48</a:t>
            </a:r>
            <a:r>
              <a:rPr lang="en-US" sz="11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</a:t>
            </a:r>
            <a:r>
              <a:rPr lang="en-US" sz="14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</a:t>
            </a:r>
            <a:endParaRPr lang="en-US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------------------------------------------------------------	0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-------------RGGR--PNDKYTAEALESIKQDLTRFEVQNNHRNNQNYTPLRYTATN	52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-EHNMSKMSTEDPRQVRN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FGTHHKALQEIRNSLLPFANETNSSRST----------S	99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AKVLGSKDATRQQQQMRATPKFGPYQKALREIRYSLLPFANESGTS-AA----------A	97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------------------------------------------------------------	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GRNDALTPDYHHAKQPME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SASPAPDVVI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AIVGQPGAGSISVSGVGVGVVGVAN	112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E</a:t>
            </a:r>
            <a:r>
              <a:rPr lang="en-US" sz="1000" kern="0" dirty="0"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NPQMLQDLQ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--------</a:t>
            </a:r>
            <a:r>
              <a:rPr lang="en-US" sz="1000" kern="0" dirty="0"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AGFDEDMVIQ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--</a:t>
            </a:r>
            <a:r>
              <a:rPr lang="en-US" sz="1000" kern="0" dirty="0"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LQKTNNRSIEAAIEFI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SKMSYQD	145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E</a:t>
            </a:r>
            <a:r>
              <a:rPr lang="en-US" sz="1000" kern="0" dirty="0"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NRQMLQELV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--------</a:t>
            </a:r>
            <a:r>
              <a:rPr lang="en-US" sz="1000" kern="0" dirty="0"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AGCDQEMAGR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--</a:t>
            </a:r>
            <a:r>
              <a:rPr lang="en-US" sz="1000" kern="0" dirty="0"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LKQTGSRSIEAALEYI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SKMGYLD	143 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------------------------------------------------------------	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GRV------------PKMMTALMPNKLIRKPSIERDTASSHYLR--CSPALDSGAGSSRS	158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PRREQMAAAAARPINASMKPGNVQQSVNRKQSWKGSKESLVPQR--HG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LGESV-AYHS	202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PRNEQIVRVIKQT---SPGKGLMPTPVTRRPSFEGTGDSFASYHQLSGTPYE-GP-SFGA	198</a:t>
            </a: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sz="1000" kern="0" dirty="0">
              <a:latin typeface="Courier New" panose="02070309020205020404" pitchFamily="49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sz="1000" kern="0" dirty="0">
              <a:latin typeface="Courier New" panose="02070309020205020404" pitchFamily="49" charset="0"/>
              <a:ea typeface="Times New Roman" panose="02020603050405020304" pitchFamily="18" charset="0"/>
            </a:endParaRP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CeWTS-1       ------------------------------------------------------------	0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Dmwts-PA      DSPHSHHTHQPSSRTVGNPGGNGG--------------FSPSPSGFSEVAPPAPPPRNPT	204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HsLATS1       ESPN-------SQTDVGRPLSGSGISAFVQAHPSNGQRVNPPPPPQVRSVTPPPPPR---	252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HsLATS2       DGPT-------ALEEMPR--------------------------PYVDYLFPGVGPHGPG	22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A87FD50-B711-5268-87E4-A14A09267D0A}"/>
              </a:ext>
            </a:extLst>
          </p:cNvPr>
          <p:cNvSpPr txBox="1"/>
          <p:nvPr/>
        </p:nvSpPr>
        <p:spPr>
          <a:xfrm flipH="1">
            <a:off x="177799" y="158375"/>
            <a:ext cx="277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7925188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FFFF6A6-C551-F945-92D5-7B2A4851E69C}"/>
              </a:ext>
            </a:extLst>
          </p:cNvPr>
          <p:cNvSpPr txBox="1"/>
          <p:nvPr/>
        </p:nvSpPr>
        <p:spPr>
          <a:xfrm>
            <a:off x="177799" y="214125"/>
            <a:ext cx="6468533" cy="86235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--------------------------------------MRPAAPGTTPNGASS-------	15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ACSAAT-----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V-----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TSQAYVKR-------RSPAL-------NNRPPA----	236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-GQT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RGTT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SWE--PNSQTKRYSGNMEYVISRISPV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GAWQEGY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LNTSP	309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HQHQH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KGYGASVEAAGAHFPLQGAHYGRP-HL----LVPGEPLGY--GVQRSPSFQS-	277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                                                     *                   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---DIRHQRGVAPIPFGSTNSAIDAHHNSEIRVGRHRAKLDEIRESLKAYEHEAGLLSSH	72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IA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T--QRGNSPVITQN-----------GLKNPQQQ-----------------------	26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MN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NQGQRGISSVP-----------------VGRQP-----------------------	329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KT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ETG--GYASLP---------------------------------------------	29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                      * : :                                              </a:t>
            </a:r>
            <a:r>
              <a:rPr lang="en-US" sz="11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sz="14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VALGSLATPSSSSVSHSDITNDNAEVMNFSSSSSNAAATTTTVSSAAVSNSNSFRTEGGG	132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------------------LTQQLKSLNLYPGGGSGAVVE-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u="sng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LIQGGAG	293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------------------IIMQSSSKFNFPSGRPGMQNGTGQT--DFMIH-QNVVPAGTV	368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------------------------------TKGQGG-------------------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G	301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                                  .                      *  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HKMRITPMPQRHLM--MD---TGANETVFRSGKE-------MIRNGNPSTTIS-STPSTT	179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--GAA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PP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u="sng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ASMQSRQSPTQSQQSDYRKSPSSGIYSATSAGSPSPITVSL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PL	351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--NRQ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u="sng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PLTAANGQSPSALQTGGSAA-----------PSSYTNGSIPQSM	409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--LAF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GLYVPHPHHKQAGPAAHQLHVLGS-R-----------SQVFASDS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SL	347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      *                          .              .       *   </a:t>
            </a:r>
            <a:endParaRPr lang="en-US" sz="1000" kern="100" dirty="0"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TEESIRIHPAGYRYDMPTPAYHMNNNAPQ-------------------YSPGYSR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u="sng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22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AKPQPRVYQA--RSQQPIIMQSVKSTQVQKPVLQTAVAPQSPSSASASNSPVHVLAA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u="sng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409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MVPN--------RNSHNMELYNISVPGLQT-----------------------------N	432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LTPS--------RNSLNVDLYELGSTSVQ------------------------------Q	369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                .        * .       :     *                               </a:t>
            </a:r>
            <a:r>
              <a:rPr lang="en-US" sz="11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sz="14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SS---PVNTRMTPVATDNYRTHLHM---------------KVHPVVKA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PTMLNH	262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QKSAAVVQQQQQAAAAAHQQQHQHQQSK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PTT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VGLNSKPNCLE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u="sng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	462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WPQSSSAPAQS-----------------SPSSGHEIP-----TWQPN--IPVRS----NS	464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WPAATLARRDS-----------------LQKPGLEA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AHVAFRPDCPVPSRT----NS	408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:        :                                  :*    *         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NKNMAPPPPPPAK--------STISIETMSEERKADNIQRLYHTSMDKKTASSVVSINVA	314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------------_AKSMQAKAATVVQQQQQQQQQQQQVQQQQVQQQQQQQQQQLQALRVL	51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FNNPLG--NRASHSANSQPSATTVTAITP------------------APIQQPVKSMRVL	504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FNSHQPRPG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GKAEPSLPAPNTVTAVTA------------------AHILHPVKSVRVL	45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                                   *:                             : ::.* </a:t>
            </a:r>
            <a:r>
              <a:rPr lang="en-US" sz="11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en-US" sz="14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SPHTTKVNV--------------GDSPLPS-----------------KSFIIGPRYTADV	343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QAQAQRERDQ-----------------RERDQRERERDQQKLANGNPGR-----------	542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KPELQTALAPTHPSWIPQPIQTVQPSPFPEGTASNVT-------------VMPPVAEAPN	551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RPEPQTAVGPSHPAWVPAPAPAPAPAPAPAAEGLDAKEEHALALGGAGAFPLDVEYGGPD	510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  .                                                         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sz="1100" kern="100" dirty="0">
              <a:latin typeface="Arial" panose="020B0604020202020204" pitchFamily="34" charset="0"/>
              <a:ea typeface="Aptos"/>
            </a:endParaRPr>
          </a:p>
        </p:txBody>
      </p:sp>
    </p:spTree>
    <p:extLst>
      <p:ext uri="{BB962C8B-B14F-4D97-AF65-F5344CB8AC3E}">
        <p14:creationId xmlns:p14="http://schemas.microsoft.com/office/powerpoint/2010/main" val="18178857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FFFF6A6-C551-F945-92D5-7B2A4851E69C}"/>
              </a:ext>
            </a:extLst>
          </p:cNvPr>
          <p:cNvSpPr txBox="1"/>
          <p:nvPr/>
        </p:nvSpPr>
        <p:spPr>
          <a:xfrm>
            <a:off x="177799" y="204291"/>
            <a:ext cx="6468533" cy="84927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DRKNFVNYKDELRPDPRLIPSTSDANHEDFRPILFKPRNLEITMKS-RAQ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</a:t>
            </a:r>
            <a:r>
              <a:rPr lang="en-US" sz="1000" kern="0" dirty="0">
                <a:highlight>
                  <a:srgbClr val="C0C0C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u="sng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Q	400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Q----------ML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u="sng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QSNNN-NNSEIK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CNNNNIQISNSNLATT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I</a:t>
            </a:r>
            <a:r>
              <a:rPr lang="en-US" sz="1000" kern="0" dirty="0">
                <a:highlight>
                  <a:srgbClr val="C0C0C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KYNN	590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Y----------QG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u="sng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PKHLL-HQNPSV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YESISK----PSKEDQPSLPKE----	590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R----------RC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00FF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u="sng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u="sng" kern="0" dirty="0">
                <a:highlight>
                  <a:srgbClr val="FF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PKHLL-LRSKSEQYDLDSLCAGME-QSLRAGPNEPEG----	553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             * *    .     ..       .         .    *         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PSEP-----------------------</a:t>
            </a:r>
            <a:r>
              <a:rPr lang="en-US" sz="1000" kern="0" dirty="0">
                <a:highlight>
                  <a:srgbClr val="D3D3D3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RVSSPIDR--TL--LEPYIKNTRRVQ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K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433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NSSNTGANSSGGSNGSTGTTASSSTSCKKIKHASPIPERKKISKEKEEERKEFRI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YS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650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-----------DESEKSYENVDSGDKEKKQITTSPITVRKN---KKDEERRESRIQ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YS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636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-----------GDKSRKSAKGDKGGKDKKQIQTSPVPVRKN---SRDEEKRESRIK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YS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599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                                :**:    .    .   :.  *::  .*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M</a:t>
            </a:r>
            <a:r>
              <a:rPr lang="en-US" sz="1000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u="sng" kern="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</a:t>
            </a:r>
            <a:r>
              <a:rPr lang="en-US" sz="1000" b="1" u="sng" kern="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ER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L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QYK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K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AQ</a:t>
            </a:r>
            <a:r>
              <a:rPr lang="en-US" sz="1000" b="1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b="1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IM</a:t>
            </a:r>
            <a:r>
              <a:rPr lang="en-US" sz="1000" b="1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KMLGL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Q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b="1" u="sng" kern="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493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AF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u="sng" kern="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</a:t>
            </a:r>
            <a:r>
              <a:rPr lang="en-US" sz="1000" b="1" u="sng" kern="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I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I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SYRQ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Y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K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VG</a:t>
            </a:r>
            <a:r>
              <a:rPr lang="en-US" sz="1000" b="1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lang="en-US" sz="1000" b="1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TQ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IE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Q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b="1" u="sng" kern="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YI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710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AF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u="sng" kern="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</a:t>
            </a:r>
            <a:r>
              <a:rPr lang="en-US" sz="1000" b="1" u="sng" kern="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L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SHQQ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H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K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VG</a:t>
            </a:r>
            <a:r>
              <a:rPr lang="en-US" sz="1000" b="1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Q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Q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Q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b="1" u="sng" kern="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YI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696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AF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u="sng" kern="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</a:t>
            </a:r>
            <a:r>
              <a:rPr lang="en-US" sz="1000" b="1" u="sng" kern="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I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TYQQ</a:t>
            </a:r>
            <a:r>
              <a:rPr lang="en-US" sz="1000" b="1" u="sng" kern="0" dirty="0">
                <a:solidFill>
                  <a:srgbClr val="00B0F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N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b="1" u="sng" kern="0" dirty="0">
                <a:solidFill>
                  <a:srgbClr val="00B0F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AG</a:t>
            </a:r>
            <a:r>
              <a:rPr lang="en-US" sz="1000" b="1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AEQ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QM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I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Q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b="1" u="sng" kern="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YN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</a:t>
            </a:r>
            <a:r>
              <a:rPr lang="en-US" sz="1000" b="1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659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  ::*:****:*.::: ::::  *  ***:**  . * :  : :*  :* ****:* **: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</a:t>
            </a: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sz="1000" kern="0" dirty="0">
              <a:latin typeface="Courier New" panose="02070309020205020404" pitchFamily="49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KSH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TVISHIGVGAFGKVSLVRKNDT-RKVYAMKSLEKADVIMKQQAAHVKAER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552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KSM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VKLKPIGVGAFGEVTLVSKIDTSNHLYAMKTLRKADVLKRNQVAHVKAER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77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KSM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VKIKTLGIGAFGEVCLARKVDT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ALYATKTLRKKDVLLRNQVAHVKAER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755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b="1" u="sng" kern="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b="1" u="sng" kern="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</a:t>
            </a:r>
            <a:r>
              <a:rPr lang="en-US" sz="1000" u="sng" kern="0" dirty="0"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KSM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VKIKTLGIGAFGEVCLACKVDT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HALYAMKTLRKKDVLNRNQVAHVKAER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718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             * **.** *. :. :*:****:* *. * ** . :** *:*.* **: ::*.********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LAEADSPWIVRLFFSFQDDACLYFIMEYVPGGDMMTLLIQKGIFEEDLARFYIAELACA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612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LAEADNNWVVKLYYSFQDKDNLYFVMDYIPGGDLMSLLIKLGIFEEELARFYIAEVTCA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83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LAEADNEWVVRLYYSFQDKDNLYFVMDYIPGGDMMSLLIRMGIFPESLARFYIAELTCA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815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LAEADNEWVVKLYYSFQDKDSLYFVMDYIPGGDMMSLLIRMEVFPEHLARFYIAELTLA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778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             ******. *:*:*::****.  ***:*:*:****:*:***:  :* * ********:: *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EYVHNVGFIHRDLKPDNILIDQHGHIKLTDFGLCTGLRWTHDRRYYGPENDHHRVDSFS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672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DSVHKMGFIHRDIKPDNILIDRDGHIKLTDFGLCTGFRWTHNSKYYQENGNHSRQDSME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89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ESVHKMGFIHRDIKPDNILIDRDGHIKLTDFGLCTGFRWTHDSKYYQS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DHPRQDSM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874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ESVHKMGFIHRDIKPDNILIDLDGHIKLTDFGLCTGFRWTHNSKYYQK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SHVRQDSME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837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             :: **::******:******** .*************:****: :**   ..* * **:.</a:t>
            </a:r>
            <a:r>
              <a:rPr lang="en-US" sz="11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 </a:t>
            </a: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sz="14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PPEVAAI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KSVKVLN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RQQTRRITAH</a:t>
            </a:r>
            <a:r>
              <a:rPr lang="en-US" sz="1000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VGTGNYMAPEVIAKTGHNQSCDWW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725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WEEYSE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GPKPTVLERRRMRDHQRVLAH</a:t>
            </a:r>
            <a:r>
              <a:rPr lang="en-US" sz="1000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VGTPNYIAPEVLERSGYTQLCDYW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945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SNEWGDPSSCRCGDRLKPLERRAARQHQRCLAH</a:t>
            </a:r>
            <a:r>
              <a:rPr lang="en-US" sz="1000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VGTPNYIAPEVLLRTGYTQLCDWW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934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SDLWDDVSNCRCGDRLKTLEQRARKQHQRCLAH</a:t>
            </a:r>
            <a:r>
              <a:rPr lang="en-US" sz="1000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VGTPNYIAPEVLLRKGYTQLCDWW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897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             .   . *:    :: :*  ******* **:****: :.*:.* **:*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eWTS-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TGVILYEMVFGRVPFHDDTPGGTQHRIKNWRNFLDFTYCGNLSKECLMMIQQLICDASS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785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Dmwts-PA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VGVILYEMLVGQPPFLANSPLETQQKVINWEKTLHIPPQAELSREATDLIRRLCASADK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1005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VGVILFEMLVGQPPFLAQTPLETQMKVINWQTSLHIPPQAKLSPEASDLIIKLCRGPE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994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sLATS2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VGVILFEMLVGQPPFLAPTPTETQLKVINWENTLHIPAQVKLSPEARDLITKLCCSADH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957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*.****:**:.*: **   :*  ** :: **.. *.:    :** *.  :* :*  . . </a:t>
            </a: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48352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FFFF6A6-C551-F945-92D5-7B2A4851E69C}"/>
              </a:ext>
            </a:extLst>
          </p:cNvPr>
          <p:cNvSpPr txBox="1"/>
          <p:nvPr/>
        </p:nvSpPr>
        <p:spPr>
          <a:xfrm>
            <a:off x="177799" y="312449"/>
            <a:ext cx="6468533" cy="30950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LGSHGKDVAERTAQVKNHPW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GIDWV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LRKLRADYIYIPRVTHDEDTSNFETFQDN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844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LGKS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--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VKSHDF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GIDFA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MRKQKA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YIPEIKHPTDTSNFDPVDPEK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1055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LGKNGA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--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IKAHPF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TIDFSSDLRQQSA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YIPKITHPTDTSNFDPVDPDK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1046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LGRNGAD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--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LKAHPF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AIDFSSDIRKQPA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YVPTISHPMDTSNFDPVDEES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	1009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             ***    *      ::* * :*  **:  ::*:  *   *:* :.*  *****: .: :.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ADKP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----------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VRGLHNPA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E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RH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FFDTDSVGCPSLRPSRRRSLRPLL	89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RSNDSTMSSGDDV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-----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QNDRTFHG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E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R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FFDDKQPPDMTDDQ----------	110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WSDDNEEENVNDTLNGWYKNGKHPEHA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E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R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FFDDNGYPYNYPKPIEYEYIN---	1103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WNDASEGSTKA-WDTLTSPNNKHPEHA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E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kern="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R</a:t>
            </a: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FFDDNGYPFRCPKPSGAEASQ---	1065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                ..                       .*:***:*:*** .                   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CeWTS-1       ENGTFNESVSEED--SSSHI--------	908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Dmwts-PA      -----------------------APVYV	1105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1       SQGSEQQSD-EDDQNTGSEIKNRDLVYV	1130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latin typeface="Courier New" panose="02070309020205020404" pitchFamily="49" charset="0"/>
                <a:ea typeface="Times New Roman" panose="02020603050405020304" pitchFamily="18" charset="0"/>
              </a:rPr>
              <a:t>HsLATS2       AESSDLESSDLVDQT-----EGCQPVYV	1088</a:t>
            </a:r>
            <a:endParaRPr lang="en-US" sz="11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sz="1000" kern="100" dirty="0">
              <a:latin typeface="Courier New" panose="02070309020205020404" pitchFamily="49" charset="0"/>
              <a:ea typeface="Aptos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44118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95DE674-56ED-8C41-B8F3-7DD3F75A643A}"/>
              </a:ext>
            </a:extLst>
          </p:cNvPr>
          <p:cNvSpPr txBox="1"/>
          <p:nvPr/>
        </p:nvSpPr>
        <p:spPr>
          <a:xfrm>
            <a:off x="177799" y="218596"/>
            <a:ext cx="6468533" cy="9041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000" b="1" kern="100" dirty="0">
                <a:solidFill>
                  <a:srgbClr val="000000"/>
                </a:solidFill>
                <a:highlight>
                  <a:srgbClr val="808000"/>
                </a:highlight>
                <a:latin typeface="Courier New" panose="02070309020205020404" pitchFamily="49" charset="0"/>
                <a:ea typeface="Aptos"/>
              </a:rPr>
              <a:t> 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solidFill>
                  <a:srgbClr val="000000"/>
                </a:solidFill>
                <a:highlight>
                  <a:srgbClr val="D3D3D3"/>
                </a:highlight>
                <a:latin typeface="Courier New" panose="02070309020205020404" pitchFamily="49" charset="0"/>
                <a:ea typeface="Aptos"/>
              </a:rPr>
              <a:t>UBA domain</a:t>
            </a:r>
            <a:r>
              <a:rPr lang="en-US" sz="1000" kern="100" dirty="0">
                <a:solidFill>
                  <a:srgbClr val="000000"/>
                </a:solidFill>
                <a:latin typeface="Courier New" panose="02070309020205020404" pitchFamily="49" charset="0"/>
                <a:ea typeface="Aptos"/>
              </a:rPr>
              <a:t>: involved in ubiquitin/proteasome pathway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Blue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S/T kinase domain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Dk blue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S_TK_X domain: kinase extension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latin typeface="Courier New" panose="02070309020205020404" pitchFamily="49" charset="0"/>
                <a:ea typeface="Aptos"/>
              </a:rPr>
              <a:t>HRD/DFG: core catalytic sequence of kinase: C-terminal tail of WTS-1 downstream of the kinase domain, likely including the hydrophobic motif and accessory regulatory features analogous to mammalian LATS1/2. 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Yellow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NTR/MOB-binding region. N-terminal regulatory region that binds MOB co-activator of NDR/LATS kinases (Parker et al., 2022). 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Underlines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: </a:t>
            </a:r>
            <a:r>
              <a:rPr lang="en-US" sz="1000" kern="100" dirty="0">
                <a:latin typeface="Cambria Math" panose="02040503050406030204" pitchFamily="18" charset="0"/>
                <a:ea typeface="Aptos"/>
                <a:cs typeface="Cambria Math" panose="02040503050406030204" pitchFamily="18" charset="0"/>
              </a:rPr>
              <a:t>⍺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MOBA and </a:t>
            </a:r>
            <a:r>
              <a:rPr lang="en-US" sz="1000" kern="100" dirty="0">
                <a:latin typeface="Cambria Math" panose="02040503050406030204" pitchFamily="18" charset="0"/>
                <a:ea typeface="Aptos"/>
                <a:cs typeface="Cambria Math" panose="02040503050406030204" pitchFamily="18" charset="0"/>
              </a:rPr>
              <a:t>⍺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MOBB: alpha helices in Warts/LATS that interact with MOB.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latin typeface="Courier New" panose="02070309020205020404" pitchFamily="49" charset="0"/>
                <a:ea typeface="Aptos"/>
              </a:rPr>
              <a:t>Conserved binding interfaces from yeast to human NDR/LATS kinases: </a:t>
            </a:r>
            <a:r>
              <a:rPr lang="en-US" sz="1000" b="1" kern="100" dirty="0">
                <a:latin typeface="Courier New" panose="02070309020205020404" pitchFamily="49" charset="0"/>
                <a:ea typeface="Aptos"/>
              </a:rPr>
              <a:t>bold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residues. </a:t>
            </a:r>
            <a:r>
              <a:rPr lang="en-US" sz="1000" b="1" kern="100" dirty="0">
                <a:solidFill>
                  <a:srgbClr val="FFC000"/>
                </a:solidFill>
                <a:latin typeface="Courier New" panose="02070309020205020404" pitchFamily="49" charset="0"/>
                <a:ea typeface="Aptos"/>
              </a:rPr>
              <a:t>Orange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hydrophobic, </a:t>
            </a:r>
            <a:r>
              <a:rPr lang="en-US" sz="1000" b="1" kern="100" dirty="0">
                <a:solidFill>
                  <a:srgbClr val="0070C0"/>
                </a:solidFill>
                <a:latin typeface="Courier New" panose="02070309020205020404" pitchFamily="49" charset="0"/>
                <a:ea typeface="Aptos"/>
              </a:rPr>
              <a:t>Blue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basic (</a:t>
            </a:r>
            <a:r>
              <a:rPr lang="en-US" sz="1000" b="1" kern="100" dirty="0">
                <a:solidFill>
                  <a:srgbClr val="00B0F0"/>
                </a:solidFill>
                <a:latin typeface="Courier New" panose="02070309020205020404" pitchFamily="49" charset="0"/>
                <a:ea typeface="Aptos"/>
              </a:rPr>
              <a:t>lt blue 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= basic, conservative), </a:t>
            </a:r>
            <a:r>
              <a:rPr lang="en-US" sz="1000" b="1" kern="100" dirty="0">
                <a:solidFill>
                  <a:srgbClr val="C00000"/>
                </a:solidFill>
                <a:latin typeface="Courier New" panose="02070309020205020404" pitchFamily="49" charset="0"/>
                <a:ea typeface="Aptos"/>
              </a:rPr>
              <a:t>Red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acidic, </a:t>
            </a:r>
            <a:r>
              <a:rPr lang="en-US" sz="1000" b="1" kern="100" dirty="0">
                <a:solidFill>
                  <a:srgbClr val="000000"/>
                </a:solidFill>
                <a:latin typeface="Courier New" panose="02070309020205020404" pitchFamily="49" charset="0"/>
                <a:ea typeface="Aptos"/>
              </a:rPr>
              <a:t>Black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identical, </a:t>
            </a:r>
            <a:r>
              <a:rPr lang="en-US" sz="1000" b="1" kern="100" dirty="0">
                <a:solidFill>
                  <a:srgbClr val="808080"/>
                </a:solidFill>
                <a:latin typeface="Courier New" panose="02070309020205020404" pitchFamily="49" charset="0"/>
                <a:ea typeface="Aptos"/>
              </a:rPr>
              <a:t>Gray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conservative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x</a:t>
            </a:r>
            <a:r>
              <a:rPr lang="en-US" sz="10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Pro-Pro-any-Tyr motif that is recognized by WW domains in Yki/YAP/TAZ (Verma et al. 2018  </a:t>
            </a: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29487715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; Iglesias-Bexiga 2015 </a:t>
            </a: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25607641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; Badouel et al. 2009 </a:t>
            </a: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19289086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)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u="sng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u="sng" kern="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YE</a:t>
            </a:r>
            <a:r>
              <a:rPr lang="en-US" sz="1000" u="sng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u="sng" kern="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u="sng" kern="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u="sng" kern="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RR</a:t>
            </a:r>
            <a:r>
              <a:rPr lang="en-US" sz="1000" kern="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: at the end of the S_TK_X domain is the hydrophobic motif(HM) and phosphorylation consensus site for Hippo/MST and CNH-domain MAP4 kinases 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>
              <a:lnSpc>
                <a:spcPct val="115000"/>
              </a:lnSpc>
            </a:pPr>
            <a:r>
              <a:rPr lang="en-US" sz="1000" kern="1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 = Activation loop autophosphosite (S909 in LATS1) 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900" kern="100" dirty="0">
                <a:latin typeface="Courier New" panose="02070309020205020404" pitchFamily="49" charset="0"/>
                <a:ea typeface="Aptos"/>
              </a:rPr>
              <a:t>&gt;CeWTS-1(UniProt = O45797. 908 aa)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900" dirty="0">
                <a:latin typeface="Courier New" panose="02070309020205020404" pitchFamily="49" charset="0"/>
                <a:ea typeface="Aptos"/>
              </a:rPr>
              <a:t>MRPAAPGTTPNGASSDIRHQRGVAPIPFGSTNSAIDAHHNSEIRVGRHRAKLDEIRESLKAYEHEAGLLSSHVALGSLATPSSSSVSHSDITNDNAEVMNFSSSSSNAAATTTTVSSAAVSNSNSFRTEGGGHKMRITPMPQRHLMMDTGANETVFRSGKEMIRNGNPSTTISSTPSTTTEESIRIHPAGYRYDMPTPAYHMNNNAPQYSPGYSRPP</a:t>
            </a:r>
            <a:r>
              <a:rPr lang="en-US" sz="900" u="sng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900" u="sng" dirty="0">
                <a:latin typeface="Courier New" panose="02070309020205020404" pitchFamily="49" charset="0"/>
                <a:ea typeface="Aptos"/>
              </a:rPr>
              <a:t>A</a:t>
            </a:r>
            <a:r>
              <a:rPr lang="en-US" sz="900" u="sng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900" dirty="0">
                <a:latin typeface="Courier New" panose="02070309020205020404" pitchFamily="49" charset="0"/>
                <a:ea typeface="Aptos"/>
              </a:rPr>
              <a:t>DSSPVNTRMTPVATDNYRTHLHMKVHPVVKAPPPNPTMLNHNKNMAPPPPPPAKSTISIETMSEERKADNIQRLYHTSMDKKTASSVVSINVASPHTTKVNVGDSPLPSKSFIIGPRYTADVDRKNFVNYKDELRPDPRLIPSTSDANHEDFRPILFKPRNLEITMKSRAQPP</a:t>
            </a:r>
            <a:r>
              <a:rPr lang="en-US" sz="900" u="sng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900" u="sng" dirty="0">
                <a:latin typeface="Courier New" panose="02070309020205020404" pitchFamily="49" charset="0"/>
                <a:ea typeface="Aptos"/>
              </a:rPr>
              <a:t>Q</a:t>
            </a:r>
            <a:r>
              <a:rPr lang="en-US" sz="900" u="sng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900" dirty="0">
                <a:latin typeface="Courier New" panose="02070309020205020404" pitchFamily="49" charset="0"/>
                <a:ea typeface="Aptos"/>
              </a:rPr>
              <a:t>NQPSEPPPKRVSSPIDRTLLEPYIKNTRRVQ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PCKPNM</a:t>
            </a:r>
            <a:r>
              <a:rPr lang="en-US" sz="900" b="1" u="sng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900" b="1" u="sng" dirty="0">
                <a:solidFill>
                  <a:srgbClr val="0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900" u="sng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900" b="1" u="sng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YM</a:t>
            </a:r>
            <a:r>
              <a:rPr lang="en-US" sz="900" b="1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900" b="1" u="sng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900" b="1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H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VER</a:t>
            </a:r>
            <a:r>
              <a:rPr lang="en-US" sz="900" b="1" u="sng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L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QYK</a:t>
            </a:r>
            <a:r>
              <a:rPr lang="en-US" sz="900" b="1" u="sng" dirty="0">
                <a:solidFill>
                  <a:srgbClr val="0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900" b="1" u="sng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K</a:t>
            </a:r>
            <a:r>
              <a:rPr lang="en-US" sz="900" b="1" u="sng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900" b="1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b="1" u="sng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900" b="1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900" b="1" u="sng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b="1" u="sng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900" b="1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V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SAQ</a:t>
            </a:r>
            <a:r>
              <a:rPr lang="en-US" sz="900" b="1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P</a:t>
            </a:r>
            <a:r>
              <a:rPr lang="en-US" sz="900" b="1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D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IM</a:t>
            </a:r>
            <a:r>
              <a:rPr lang="en-US" sz="900" b="1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KMLGL</a:t>
            </a:r>
            <a:r>
              <a:rPr lang="en-US" sz="900" b="1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Q</a:t>
            </a:r>
            <a:r>
              <a:rPr lang="en-US" sz="900" b="1" u="sng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b="1" u="sng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900" b="1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b="1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T</a:t>
            </a:r>
            <a:r>
              <a:rPr lang="en-US" sz="900" b="1" u="sng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900" b="1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900" b="1" u="sng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R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900" b="1" u="sng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b="1" u="sng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900" u="sng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SKSH</a:t>
            </a:r>
            <a:r>
              <a:rPr lang="en-US" sz="9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FTVISHIGVGAFGKVSLVRKNDTRKVYAMKSLEKADVIMKQQAAHVKAERDILAEADSPWIVRLFFSFQDDACLYFIMEYVPGGDMMTLLIQKGIFEEDLARFYIAELACAIEYVHNVGFIHRDLKPDNILIDQHGHIKLTDFGLCTGLRWTHDRRYYGPENDHHRVDSFSLPPEVAAIDKSVKVLNVRQQTRRITAH</a:t>
            </a:r>
            <a:r>
              <a:rPr lang="en-US" sz="9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9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LVGTGNYMAPEVIAKTGHNQSCDWWSTGVILYEMVFGRVPFHDDTPGGTQHRIKNWRNFLDFTYCGNLSKECLMMIQQLICDASSRLGSHGKDVAERTAQVKNHPWF</a:t>
            </a:r>
            <a:r>
              <a:rPr lang="en-US" sz="9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RGIDWVNLRKLRADYIYIPRVTHDEDTSNFETFQDNDRADKPNVRGLHNPA</a:t>
            </a:r>
            <a:r>
              <a:rPr lang="en-US" sz="9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9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YE</a:t>
            </a:r>
            <a:r>
              <a:rPr lang="en-US" sz="9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9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T</a:t>
            </a:r>
            <a:r>
              <a:rPr lang="en-US" sz="9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YRH</a:t>
            </a:r>
            <a:r>
              <a:rPr lang="en-US" sz="900" dirty="0">
                <a:latin typeface="Courier New" panose="02070309020205020404" pitchFamily="49" charset="0"/>
                <a:ea typeface="Aptos"/>
              </a:rPr>
              <a:t>FFDTDSVGCPSLRPSRRRSLRPLLENGTFNESVSEEDSSSHI</a:t>
            </a:r>
            <a:r>
              <a:rPr lang="en-US" sz="900" dirty="0"/>
              <a:t> </a:t>
            </a:r>
            <a:endParaRPr lang="en-US" sz="900" kern="100" dirty="0">
              <a:latin typeface="Courier New" panose="02070309020205020404" pitchFamily="49" charset="0"/>
            </a:endParaRPr>
          </a:p>
          <a:p>
            <a:pPr marR="1314450">
              <a:lnSpc>
                <a:spcPct val="115000"/>
              </a:lnSpc>
            </a:pP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900" kern="100" dirty="0">
                <a:latin typeface="Courier New" panose="02070309020205020404" pitchFamily="49" charset="0"/>
                <a:ea typeface="Aptos"/>
              </a:rPr>
              <a:t>&gt;Dmwts-PA(UniProt = Q9VA38. 1105 aa)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900" kern="100" dirty="0">
                <a:latin typeface="Courier New" panose="02070309020205020404" pitchFamily="49" charset="0"/>
                <a:ea typeface="Aptos"/>
              </a:rPr>
              <a:t>MHPAGEKRGGRPNDKYTAEALESIKQDLTRFEVQNNHRNNQNYTPLRYTATNGRNDALTPDYHHAKQPMEPPPSASPAPDVVIPPPPAIVGQPGAGSISVSGVGVGVVGVANGRVPKMMTALMPNKLIRKPSIERDTASSHYLRCSPALDSGAGSSRSDSPHSHHTHQPSSRTVGNPGGNGGFSPSPSGFSEVAPPAPPPRNPTACSAATPPPPVPPTSQAYVKRRSPALNNRPPAIAPPTQRGNSPVITQNGLKNPQQQLTQQLKSLNLYPGGGSGAVVEP</a:t>
            </a:r>
            <a:r>
              <a:rPr lang="en-US" sz="9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900" u="sng" kern="100" dirty="0">
                <a:latin typeface="Courier New" panose="02070309020205020404" pitchFamily="49" charset="0"/>
                <a:ea typeface="Aptos"/>
              </a:rPr>
              <a:t>P</a:t>
            </a:r>
            <a:r>
              <a:rPr lang="en-US" sz="9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900" kern="100" dirty="0">
                <a:latin typeface="Courier New" panose="02070309020205020404" pitchFamily="49" charset="0"/>
                <a:ea typeface="Aptos"/>
              </a:rPr>
              <a:t>LIQGGAGGAAPPPP</a:t>
            </a:r>
            <a:r>
              <a:rPr lang="en-US" sz="9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900" u="sng" kern="100" dirty="0">
                <a:latin typeface="Courier New" panose="02070309020205020404" pitchFamily="49" charset="0"/>
                <a:ea typeface="Aptos"/>
              </a:rPr>
              <a:t>S</a:t>
            </a:r>
            <a:r>
              <a:rPr lang="en-US" sz="9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900" kern="100" dirty="0">
                <a:latin typeface="Courier New" panose="02070309020205020404" pitchFamily="49" charset="0"/>
                <a:ea typeface="Aptos"/>
              </a:rPr>
              <a:t>TASMQSRQSPTQSQQSDYRKSPSSGIYSATSAGSPSPITVSLPPAPLAKPQPRVYQARSQQPIIMQSVKSTQVQKPVLQTAVAPQSPSSASASNSPVHVLAA</a:t>
            </a:r>
            <a:r>
              <a:rPr lang="en-US" sz="9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900" u="sng" kern="100" dirty="0">
                <a:latin typeface="Courier New" panose="02070309020205020404" pitchFamily="49" charset="0"/>
                <a:ea typeface="Aptos"/>
              </a:rPr>
              <a:t>S</a:t>
            </a:r>
            <a:r>
              <a:rPr lang="en-US" sz="9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900" kern="100" dirty="0">
                <a:latin typeface="Courier New" panose="02070309020205020404" pitchFamily="49" charset="0"/>
                <a:ea typeface="Aptos"/>
              </a:rPr>
              <a:t>PQKSAAVVQQQQQAAAAAHQQQHQHQQSKPPTPTTPPLVGLNSKPNCLE</a:t>
            </a:r>
            <a:r>
              <a:rPr lang="en-US" sz="9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900" u="sng" kern="100" dirty="0">
                <a:latin typeface="Courier New" panose="02070309020205020404" pitchFamily="49" charset="0"/>
                <a:ea typeface="Aptos"/>
              </a:rPr>
              <a:t>S</a:t>
            </a:r>
            <a:r>
              <a:rPr lang="en-US" sz="9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900" kern="100" dirty="0">
                <a:latin typeface="Courier New" panose="02070309020205020404" pitchFamily="49" charset="0"/>
                <a:ea typeface="Aptos"/>
              </a:rPr>
              <a:t>AKSMQAKAATVVQQQQQQQQQQQQVQQQQVQQQQQQQQQQLQALRVLQAQAQRERDQRERDQRERERDQQKLANGNPGRQMLP</a:t>
            </a:r>
            <a:r>
              <a:rPr lang="en-US" sz="9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900" u="sng" kern="100" dirty="0">
                <a:latin typeface="Courier New" panose="02070309020205020404" pitchFamily="49" charset="0"/>
                <a:ea typeface="Aptos"/>
              </a:rPr>
              <a:t>P</a:t>
            </a:r>
            <a:r>
              <a:rPr lang="en-US" sz="9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900" kern="100" dirty="0">
                <a:latin typeface="Courier New" panose="02070309020205020404" pitchFamily="49" charset="0"/>
                <a:ea typeface="Aptos"/>
              </a:rPr>
              <a:t>QSNNNNNSEIKPPSCNNNNIQISNSNLATTPPIPPAKYNNNSSNTGANSSGGSNGSTGTTASSSTSCKKIKHASPIPERKKISKEKEEERKEFRIR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YSPQAF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u="sng" kern="10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900" b="1" u="sng" kern="10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FM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9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H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IE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</a:t>
            </a:r>
            <a:r>
              <a:rPr lang="en-US" sz="9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VI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SYRQ</a:t>
            </a:r>
            <a:r>
              <a:rPr lang="en-US" sz="9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TY</a:t>
            </a:r>
            <a:r>
              <a:rPr lang="en-US" sz="9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9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</a:t>
            </a:r>
            <a:r>
              <a:rPr lang="en-US" sz="9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900" b="1" u="sng" kern="100" dirty="0">
                <a:solidFill>
                  <a:srgbClr val="0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900" b="1" u="sng" kern="10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H</a:t>
            </a:r>
            <a:r>
              <a:rPr lang="en-US" sz="9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VG</a:t>
            </a:r>
            <a:r>
              <a:rPr lang="en-US" sz="900" b="1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9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P</a:t>
            </a:r>
            <a:r>
              <a:rPr lang="en-US" sz="900" b="1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D</a:t>
            </a:r>
            <a:r>
              <a:rPr lang="en-US" sz="9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TQ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IEM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9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Q</a:t>
            </a:r>
            <a:r>
              <a:rPr lang="en-US" sz="9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b="1" u="sng" kern="10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9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I</a:t>
            </a:r>
            <a:r>
              <a:rPr lang="en-US" sz="9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9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9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R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A</a:t>
            </a:r>
            <a:r>
              <a:rPr lang="en-US" sz="9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9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9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DKSM</a:t>
            </a:r>
            <a:r>
              <a:rPr lang="en-US" sz="900" kern="1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FVKLKPIGVGAFGEVTLVSKIDTSNHLYAMKTLRKADVLKRNQVAHVKAERDILAEADNNWVVKLYYSFQDKDNLYFVMDYIPGGDLMSLLIKLGIFEEELARFYIAEVTCAVDSVHKMGFIHRDIKPDNILIDRDGHIKLTDFGLCTGFRWTHNSKYYQENGNHSRQDSMEPWEEYSENGPKPTVLERRRMRDHQRVLAH</a:t>
            </a:r>
            <a:r>
              <a:rPr lang="en-US" sz="900" kern="1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900" kern="1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LVGTPNYIAPEVLERSGYTQLCDYWSVGVILYEMLVGQPPFLANSPLETQQKVINWEKTLHIPPQAELSREATDLIRRLCASADKRLGKSVDEVKSHDFF</a:t>
            </a:r>
            <a:r>
              <a:rPr lang="en-US" sz="9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KGIDFADMRKQKAPYIPEIKHPTDTSNFDPVDPEKLRSNDSTMSSGDDVDQNDRTFHG</a:t>
            </a:r>
            <a:r>
              <a:rPr lang="en-US" sz="900" kern="1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9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FE</a:t>
            </a:r>
            <a:r>
              <a:rPr lang="en-US" sz="900" kern="1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900" kern="1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T</a:t>
            </a:r>
            <a:r>
              <a:rPr lang="en-US" sz="900" kern="1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9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RR</a:t>
            </a:r>
            <a:r>
              <a:rPr lang="en-US" sz="900" kern="100" dirty="0">
                <a:latin typeface="Courier New" panose="02070309020205020404" pitchFamily="49" charset="0"/>
                <a:ea typeface="Aptos"/>
              </a:rPr>
              <a:t>FFDDKQPPDMTDDQAPVYV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3AF5E6A-38C9-C15B-D358-E3F53563949F}"/>
              </a:ext>
            </a:extLst>
          </p:cNvPr>
          <p:cNvSpPr txBox="1"/>
          <p:nvPr/>
        </p:nvSpPr>
        <p:spPr>
          <a:xfrm flipH="1">
            <a:off x="207859" y="142292"/>
            <a:ext cx="277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6408667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95DE674-56ED-8C41-B8F3-7DD3F75A643A}"/>
              </a:ext>
            </a:extLst>
          </p:cNvPr>
          <p:cNvSpPr txBox="1"/>
          <p:nvPr/>
        </p:nvSpPr>
        <p:spPr>
          <a:xfrm>
            <a:off x="177799" y="135467"/>
            <a:ext cx="6468533" cy="7431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1314450">
              <a:lnSpc>
                <a:spcPct val="115000"/>
              </a:lnSpc>
            </a:pPr>
            <a:r>
              <a:rPr lang="en-US" sz="1000" kern="100" dirty="0">
                <a:latin typeface="Courier New" panose="02070309020205020404" pitchFamily="49" charset="0"/>
                <a:ea typeface="Aptos"/>
              </a:rPr>
              <a:t> 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1000" kern="100" dirty="0">
                <a:latin typeface="Courier New" panose="02070309020205020404" pitchFamily="49" charset="0"/>
                <a:ea typeface="Aptos"/>
              </a:rPr>
              <a:t>&gt;HsLATS1(UniProt =</a:t>
            </a:r>
            <a:r>
              <a:rPr lang="en-US" sz="1600" b="1" kern="1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O95835</a:t>
            </a:r>
            <a:r>
              <a:rPr lang="en-US" sz="1000" b="1" kern="100" dirty="0">
                <a:latin typeface="Courier New" panose="02070309020205020404" pitchFamily="49" charset="0"/>
                <a:ea typeface="Aptos"/>
              </a:rPr>
              <a:t>. 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1130 aa)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1000" kern="100" dirty="0">
                <a:latin typeface="Courier New" panose="02070309020205020404" pitchFamily="49" charset="0"/>
                <a:ea typeface="Aptos"/>
              </a:rPr>
              <a:t>MKRSEKPEGYRQMRPKTFPASNYTVSSRQMLQEIRESLRNLSKPSDAAKAEHNMSKMSTEDPRQVRNPPKFGTHHKALQEIRNSLLPFANETNSSRSTSE</a:t>
            </a:r>
            <a:r>
              <a:rPr lang="en-US" sz="1000" kern="100" dirty="0">
                <a:highlight>
                  <a:srgbClr val="D3D3D3"/>
                </a:highlight>
                <a:latin typeface="Courier New" panose="02070309020205020404" pitchFamily="49" charset="0"/>
                <a:ea typeface="Aptos"/>
              </a:rPr>
              <a:t>VNPQMLQDLQAAGFDEDMVIQALQKTNNRSIEAAIEFI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SKMSYQDPRREQMAAAAARPINASMKPGNVQQSVNRKQSWKGSKESLVPQRHGPPLGESVAYHSESPNSQTDVGRPLSGSGISAFVQAHPSNGQRVNPPPPPQVRSVTPPPPPRGQTPPPRGTTPPPPSWEPNSQTKRYSGNMEYVISRISPVPPGAWQEGYPPPPLNTSPMNPPNQGQRGISSVPVGRQPIIMQSSSKFNFPSGRPGMQNGTGQTDFMIHQNVVPAGTVNRQP</a:t>
            </a:r>
            <a:r>
              <a:rPr lang="en-US" sz="10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P</a:t>
            </a:r>
            <a:r>
              <a:rPr lang="en-US" sz="10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PLTAANGQSPSALQTGGSAAPSSYTNGSIPQSMMVPNRNSHNMELYNISVPGLQTNWPQSSSAPAQSSPSSGHEIPTWQPNIPVRSNSFNNPLGNRASHSANSQPSATTVTAITPAPIQQPVKSMRVLKPELQTALAPTHPSWIPQPIQTVQPSPFPEGTASNVTVMPPVAEAPNYQGP</a:t>
            </a:r>
            <a:r>
              <a:rPr lang="en-US" sz="10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P</a:t>
            </a:r>
            <a:r>
              <a:rPr lang="en-US" sz="10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PKHLLHQNPSVPPYESISKPSKEDQPSLPKEDESEKSYENVDSGDKEKKQITTSPITVRKNKKDEERRESRIQ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SYSPQAF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u="sng" kern="10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1000" b="1" u="sng" kern="10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FM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H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VE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VL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SHQQ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H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1000" b="1" u="sng" kern="10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VG</a:t>
            </a:r>
            <a:r>
              <a:rPr lang="en-US" sz="1000" b="1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1000" b="1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1000" b="1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D</a:t>
            </a: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AQ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DQM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CQ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b="1" u="sng" kern="10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I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R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A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DKSM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FVKIKTLGIGAFGEVCLARKVDTKALYATKTLRKKDVLLRNQVAHVKAERDILAEADNEWVVRLYYSFQDKDNLYFVMDYIPGGDMMSLLIRMGIFPESLARFYIAELTCAVESVHKMGFIHRDIKPDNILIDRDGHIKLTDFGLCTGFRWTHDSKYYQSGDHPRQDSMDFSNEWGDPSSCRCGDRLKPLERRAARQHQRCLAH</a:t>
            </a:r>
            <a:r>
              <a:rPr lang="en-US" sz="1000" kern="1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LVGTPNYIAPEVLLRTGYTQLCDWWSVGVILFEMLVGQPPFLAQTPLETQMKVINWQTSLHIPPQAKLSPEASDLIIKLCRGPEDRLGKNGADEIKAHPFF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KTIDFSSDLRQQSASYIPKITHPTDTSNFDPVDPDKLWSDDNEEENVNDTLNGWYKNGKHPEHA</a:t>
            </a:r>
            <a:r>
              <a:rPr lang="en-US" sz="1000" kern="1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YE</a:t>
            </a:r>
            <a:r>
              <a:rPr lang="en-US" sz="1000" kern="1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1000" kern="1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T</a:t>
            </a:r>
            <a:r>
              <a:rPr lang="en-US" sz="1000" kern="1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RR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FFDDNGYPYNYPKPIEYEYINSQGSEQQSDEDDQNTGSEIKNRDLVYV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1000" kern="100" dirty="0">
                <a:latin typeface="Courier New" panose="02070309020205020404" pitchFamily="49" charset="0"/>
                <a:ea typeface="Aptos"/>
              </a:rPr>
              <a:t> 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1000" kern="100" dirty="0">
                <a:latin typeface="Courier New" panose="02070309020205020404" pitchFamily="49" charset="0"/>
                <a:ea typeface="Aptos"/>
              </a:rPr>
              <a:t>&gt;HsLATS2(UniProt = Q9NRM7. 1088 aa)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1000" kern="100" dirty="0">
                <a:latin typeface="Courier New" panose="02070309020205020404" pitchFamily="49" charset="0"/>
                <a:ea typeface="Aptos"/>
              </a:rPr>
              <a:t>MRPKTFPATTYSGNSRQRLQEIREGLKQPSKSSVQGLPAGPNSDTSLDAKVLGSKDATRQQQQMRATPKFGPYQKALREIRYSLLPFANESGTSAAAEV</a:t>
            </a:r>
            <a:r>
              <a:rPr lang="en-US" sz="1000" kern="100" dirty="0">
                <a:highlight>
                  <a:srgbClr val="D3D3D3"/>
                </a:highlight>
                <a:latin typeface="Courier New" panose="02070309020205020404" pitchFamily="49" charset="0"/>
                <a:ea typeface="Aptos"/>
              </a:rPr>
              <a:t>NRQMLQELVNAGCDQEMAGRALKQTGSRSIEAALEYISKM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GYLDPRNEQIVRVIKQTSPGKGLMPTPVTRRPSFEGTGDSFASYHQLSGTPYEGPSFGADGPTALEEMPRPYVDYLFPGVGPHGPGHQHQHPPKGYGASVEAAGAHFPLQGAHYGRPHLLVPGEPLGYGVQRSPSFQSKTPPETGGYASLPTKGQGGPPGAGLAFPPPAAGLYVPHPHHKQAGPAAHQLHVLGSRSQVFASDSPPQSLLTPSRNSLNVDLYELGSTSVQQWPAATLARRDSLQKPGLEAPPRAHVAFRPDCPVPSRTNSFNSHQPRPGPPGKAEPSLPAPNTVTAVTAAHILHPVKSVRVLRPEPQTAVGPSHPAWVPAPAPAPAPAPAPAAEGLDAKEEHALALGGAGAFPLDVEYGGPDRRC</a:t>
            </a: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P</a:t>
            </a:r>
            <a:r>
              <a:rPr lang="en-US" sz="1000" u="sng" kern="100" dirty="0">
                <a:highlight>
                  <a:srgbClr val="00FFFF"/>
                </a:highlight>
                <a:latin typeface="Courier New" panose="02070309020205020404" pitchFamily="49" charset="0"/>
                <a:ea typeface="Aptos"/>
              </a:rPr>
              <a:t>PP</a:t>
            </a: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P</a:t>
            </a:r>
            <a:r>
              <a:rPr lang="en-US" sz="1000" u="sng" kern="100" dirty="0">
                <a:highlight>
                  <a:srgbClr val="FF00FF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1000" u="sng" kern="100" dirty="0">
                <a:latin typeface="Courier New" panose="02070309020205020404" pitchFamily="49" charset="0"/>
                <a:ea typeface="Aptos"/>
              </a:rPr>
              <a:t>P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KHLLLRSKSEQYDLDSLCAGMEQSLRAGPNEPEGGDKSRKSAKGDKGGKDKKQIQTSPVPVRKNSRDEEKRESRIK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SYSPYAF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u="sng" kern="10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1000" b="1" u="sng" kern="100" dirty="0">
                <a:solidFill>
                  <a:srgbClr val="FFC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FM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H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VE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VI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TYQQ</a:t>
            </a:r>
            <a:r>
              <a:rPr lang="en-US" sz="1000" b="1" u="sng" kern="100" dirty="0">
                <a:solidFill>
                  <a:srgbClr val="00B0F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VN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1000" b="1" u="sng" kern="100" dirty="0">
                <a:solidFill>
                  <a:srgbClr val="00B0F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1000" b="1" u="sng" kern="10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Q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A</a:t>
            </a: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AG</a:t>
            </a:r>
            <a:r>
              <a:rPr lang="en-US" sz="1000" b="1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1000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CEAEQ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QM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I</a:t>
            </a:r>
            <a:r>
              <a:rPr lang="en-US" sz="1000" b="1" u="sng" kern="100" dirty="0">
                <a:solidFill>
                  <a:srgbClr val="0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YQ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b="1" u="sng" kern="100" dirty="0">
                <a:solidFill>
                  <a:srgbClr val="C0000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E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Y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N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R</a:t>
            </a:r>
            <a:r>
              <a:rPr lang="en-US" sz="1000" b="1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L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R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A</a:t>
            </a:r>
            <a:r>
              <a:rPr lang="en-US" sz="1000" b="1" u="sng" kern="100" dirty="0">
                <a:solidFill>
                  <a:srgbClr val="0070C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K</a:t>
            </a:r>
            <a:r>
              <a:rPr lang="en-US" sz="1000" b="1" u="sng" kern="100" dirty="0">
                <a:solidFill>
                  <a:srgbClr val="808080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M</a:t>
            </a:r>
            <a:r>
              <a:rPr lang="en-US" sz="1000" u="sng" kern="100" dirty="0">
                <a:highlight>
                  <a:srgbClr val="FFFF00"/>
                </a:highlight>
                <a:latin typeface="Courier New" panose="02070309020205020404" pitchFamily="49" charset="0"/>
                <a:ea typeface="Aptos"/>
              </a:rPr>
              <a:t>DKSM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FVKIKTLGIGAFGEVCLACKVDTHALYAMKTLRKKDVLNRNQVAHVKAERDILAEADNEWVVKLYYSFQDKDSLYFVMDYIPGGDMMSLLIRMEVFPEHLARFYIAELTLAIESVHKMGFIHRDIKPDNILIDLDGHIKLTDFGLCTGFRWTHNSKYYQKGSHVRQDSMEPSDLWDDVSNCRCGDRLKTLEQRARKQHQRCLAH</a:t>
            </a:r>
            <a:r>
              <a:rPr lang="en-US" sz="1000" kern="1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S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Aptos"/>
              </a:rPr>
              <a:t>LVGTPNYIAPEVLLRKGYTQLCDWWSVGVILFEMLVGQPPFLAPTPTETQLKVINWENTLHIPAQVKLSPEARDLITKLCCSADHRLGRNGADDLKAHPFF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SAIDFSSDIRKQPAPYVPTISHPMDTSNFDPVDEESPWNDASEGSTKAWDTLTSPNNKHPEHA</a:t>
            </a:r>
            <a:r>
              <a:rPr lang="en-US" sz="1000" kern="1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YE</a:t>
            </a:r>
            <a:r>
              <a:rPr lang="en-US" sz="1000" kern="1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1000" kern="100" dirty="0">
                <a:solidFill>
                  <a:srgbClr val="FFFF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Aptos"/>
              </a:rPr>
              <a:t>T</a:t>
            </a:r>
            <a:r>
              <a:rPr lang="en-US" sz="1000" kern="100" dirty="0">
                <a:solidFill>
                  <a:srgbClr val="FFFF00"/>
                </a:solidFill>
                <a:highlight>
                  <a:srgbClr val="800080"/>
                </a:highlight>
                <a:latin typeface="Courier New" panose="02070309020205020404" pitchFamily="49" charset="0"/>
                <a:ea typeface="Aptos"/>
              </a:rPr>
              <a:t>F</a:t>
            </a:r>
            <a:r>
              <a:rPr lang="en-US" sz="1000" kern="100" dirty="0">
                <a:solidFill>
                  <a:srgbClr val="FFFF00"/>
                </a:solidFill>
                <a:highlight>
                  <a:srgbClr val="00008B"/>
                </a:highlight>
                <a:latin typeface="Courier New" panose="02070309020205020404" pitchFamily="49" charset="0"/>
                <a:ea typeface="Aptos"/>
              </a:rPr>
              <a:t>RR</a:t>
            </a:r>
            <a:r>
              <a:rPr lang="en-US" sz="1000" kern="100" dirty="0">
                <a:latin typeface="Courier New" panose="02070309020205020404" pitchFamily="49" charset="0"/>
                <a:ea typeface="Aptos"/>
              </a:rPr>
              <a:t>FFDDNGYPFRCPKPSGAEASQAESSDLESSDLVDQTEGCQPVYV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pPr marR="1314450">
              <a:lnSpc>
                <a:spcPct val="115000"/>
              </a:lnSpc>
            </a:pPr>
            <a:r>
              <a:rPr lang="en-US" sz="1000" kern="100" dirty="0">
                <a:latin typeface="Courier New" panose="02070309020205020404" pitchFamily="49" charset="0"/>
                <a:ea typeface="Aptos"/>
              </a:rPr>
              <a:t> </a:t>
            </a:r>
            <a:endParaRPr lang="en-US" sz="900" kern="100" dirty="0">
              <a:latin typeface="Arial" panose="020B0604020202020204" pitchFamily="34" charset="0"/>
              <a:ea typeface="Aptos"/>
            </a:endParaRPr>
          </a:p>
          <a:p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4159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02</TotalTime>
  <Words>1457</Words>
  <Application>Microsoft Macintosh PowerPoint</Application>
  <PresentationFormat>Letter Paper (8.5x11 in)</PresentationFormat>
  <Paragraphs>280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Cambria Math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ynh, Linh</dc:creator>
  <cp:lastModifiedBy>Reiner, David J</cp:lastModifiedBy>
  <cp:revision>440</cp:revision>
  <cp:lastPrinted>2025-12-30T16:59:56Z</cp:lastPrinted>
  <dcterms:created xsi:type="dcterms:W3CDTF">2025-01-17T22:21:34Z</dcterms:created>
  <dcterms:modified xsi:type="dcterms:W3CDTF">2026-02-23T18:10:51Z</dcterms:modified>
</cp:coreProperties>
</file>